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sldIdLst>
    <p:sldId id="263" r:id="rId3"/>
    <p:sldId id="265" r:id="rId4"/>
    <p:sldId id="262" r:id="rId5"/>
    <p:sldId id="260" r:id="rId6"/>
    <p:sldId id="264" r:id="rId7"/>
  </p:sldIdLst>
  <p:sldSz cx="12192000" cy="6858000"/>
  <p:notesSz cx="6858000" cy="9144000"/>
  <p:defaultTextStyle>
    <a:defPPr>
      <a:defRPr lang="en-A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78" d="100"/>
          <a:sy n="78" d="100"/>
        </p:scale>
        <p:origin x="118" y="3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2" Type="http://schemas.microsoft.com/office/2016/11/relationships/changesInfo" Target="changesInfos/changesInfo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tableStyles" Target="tableStyles.xml"/><Relationship Id="rId5" Type="http://schemas.openxmlformats.org/officeDocument/2006/relationships/slide" Target="slides/slide3.xml"/><Relationship Id="rId10" Type="http://schemas.openxmlformats.org/officeDocument/2006/relationships/theme" Target="theme/theme1.xml"/><Relationship Id="rId4" Type="http://schemas.openxmlformats.org/officeDocument/2006/relationships/slide" Target="slides/slide2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ami Elamin Mustafa Mohammed" userId="3bc523f75e54a6a4" providerId="LiveId" clId="{B3078D4E-DAAB-47E5-BFF3-560C5FEEC4EA}"/>
    <pc:docChg chg="undo custSel addSld delSld modSld sldOrd">
      <pc:chgData name="Sami Elamin Mustafa Mohammed" userId="3bc523f75e54a6a4" providerId="LiveId" clId="{B3078D4E-DAAB-47E5-BFF3-560C5FEEC4EA}" dt="2021-11-07T23:15:34.151" v="3576" actId="21"/>
      <pc:docMkLst>
        <pc:docMk/>
      </pc:docMkLst>
      <pc:sldChg chg="del">
        <pc:chgData name="Sami Elamin Mustafa Mohammed" userId="3bc523f75e54a6a4" providerId="LiveId" clId="{B3078D4E-DAAB-47E5-BFF3-560C5FEEC4EA}" dt="2021-11-06T20:11:58.792" v="7" actId="47"/>
        <pc:sldMkLst>
          <pc:docMk/>
          <pc:sldMk cId="435820537" sldId="258"/>
        </pc:sldMkLst>
      </pc:sldChg>
      <pc:sldChg chg="addSp delSp modSp mod">
        <pc:chgData name="Sami Elamin Mustafa Mohammed" userId="3bc523f75e54a6a4" providerId="LiveId" clId="{B3078D4E-DAAB-47E5-BFF3-560C5FEEC4EA}" dt="2021-11-07T23:15:34.151" v="3576" actId="21"/>
        <pc:sldMkLst>
          <pc:docMk/>
          <pc:sldMk cId="81758461" sldId="260"/>
        </pc:sldMkLst>
        <pc:spChg chg="add mod">
          <ac:chgData name="Sami Elamin Mustafa Mohammed" userId="3bc523f75e54a6a4" providerId="LiveId" clId="{B3078D4E-DAAB-47E5-BFF3-560C5FEEC4EA}" dt="2021-11-07T23:14:40.674" v="3571" actId="1076"/>
          <ac:spMkLst>
            <pc:docMk/>
            <pc:sldMk cId="81758461" sldId="260"/>
            <ac:spMk id="3" creationId="{6AE49EB4-12F2-47AE-A588-9E7D258E45EC}"/>
          </ac:spMkLst>
        </pc:spChg>
        <pc:spChg chg="del mod">
          <ac:chgData name="Sami Elamin Mustafa Mohammed" userId="3bc523f75e54a6a4" providerId="LiveId" clId="{B3078D4E-DAAB-47E5-BFF3-560C5FEEC4EA}" dt="2021-11-07T14:01:44.745" v="1324" actId="478"/>
          <ac:spMkLst>
            <pc:docMk/>
            <pc:sldMk cId="81758461" sldId="260"/>
            <ac:spMk id="7" creationId="{A94D8FF7-EA87-4804-8BFF-A7DB24A2CBDE}"/>
          </ac:spMkLst>
        </pc:spChg>
        <pc:spChg chg="del">
          <ac:chgData name="Sami Elamin Mustafa Mohammed" userId="3bc523f75e54a6a4" providerId="LiveId" clId="{B3078D4E-DAAB-47E5-BFF3-560C5FEEC4EA}" dt="2021-11-07T14:01:48.706" v="1326" actId="478"/>
          <ac:spMkLst>
            <pc:docMk/>
            <pc:sldMk cId="81758461" sldId="260"/>
            <ac:spMk id="8" creationId="{59BB5640-E17A-454F-AFFE-C43E75B3A5CD}"/>
          </ac:spMkLst>
        </pc:spChg>
        <pc:spChg chg="del">
          <ac:chgData name="Sami Elamin Mustafa Mohammed" userId="3bc523f75e54a6a4" providerId="LiveId" clId="{B3078D4E-DAAB-47E5-BFF3-560C5FEEC4EA}" dt="2021-11-07T14:03:34.055" v="1328" actId="478"/>
          <ac:spMkLst>
            <pc:docMk/>
            <pc:sldMk cId="81758461" sldId="260"/>
            <ac:spMk id="13" creationId="{00000000-0000-0000-0000-000000000000}"/>
          </ac:spMkLst>
        </pc:spChg>
        <pc:spChg chg="del">
          <ac:chgData name="Sami Elamin Mustafa Mohammed" userId="3bc523f75e54a6a4" providerId="LiveId" clId="{B3078D4E-DAAB-47E5-BFF3-560C5FEEC4EA}" dt="2021-11-07T23:12:41.583" v="3131" actId="478"/>
          <ac:spMkLst>
            <pc:docMk/>
            <pc:sldMk cId="81758461" sldId="260"/>
            <ac:spMk id="14" creationId="{96CF36E0-D43B-445C-9AEE-CDCAD74794E1}"/>
          </ac:spMkLst>
        </pc:spChg>
        <pc:spChg chg="add del">
          <ac:chgData name="Sami Elamin Mustafa Mohammed" userId="3bc523f75e54a6a4" providerId="LiveId" clId="{B3078D4E-DAAB-47E5-BFF3-560C5FEEC4EA}" dt="2021-11-07T23:15:34.151" v="3576" actId="21"/>
          <ac:spMkLst>
            <pc:docMk/>
            <pc:sldMk cId="81758461" sldId="260"/>
            <ac:spMk id="15" creationId="{C7DD7D73-69F4-4970-A9E1-023D17E77B38}"/>
          </ac:spMkLst>
        </pc:spChg>
        <pc:spChg chg="add mod">
          <ac:chgData name="Sami Elamin Mustafa Mohammed" userId="3bc523f75e54a6a4" providerId="LiveId" clId="{B3078D4E-DAAB-47E5-BFF3-560C5FEEC4EA}" dt="2021-11-07T23:13:03.015" v="3302" actId="14100"/>
          <ac:spMkLst>
            <pc:docMk/>
            <pc:sldMk cId="81758461" sldId="260"/>
            <ac:spMk id="17" creationId="{4E5040C1-114A-4C67-8782-A1CAC54866E0}"/>
          </ac:spMkLst>
        </pc:spChg>
        <pc:spChg chg="add del mod">
          <ac:chgData name="Sami Elamin Mustafa Mohammed" userId="3bc523f75e54a6a4" providerId="LiveId" clId="{B3078D4E-DAAB-47E5-BFF3-560C5FEEC4EA}" dt="2021-11-07T23:15:34.151" v="3576" actId="21"/>
          <ac:spMkLst>
            <pc:docMk/>
            <pc:sldMk cId="81758461" sldId="260"/>
            <ac:spMk id="18" creationId="{5AB17470-7B4F-4517-B4FD-49E54BF970DC}"/>
          </ac:spMkLst>
        </pc:spChg>
        <pc:spChg chg="del">
          <ac:chgData name="Sami Elamin Mustafa Mohammed" userId="3bc523f75e54a6a4" providerId="LiveId" clId="{B3078D4E-DAAB-47E5-BFF3-560C5FEEC4EA}" dt="2021-11-07T14:01:49.965" v="1327" actId="478"/>
          <ac:spMkLst>
            <pc:docMk/>
            <pc:sldMk cId="81758461" sldId="260"/>
            <ac:spMk id="19" creationId="{D2EAB4BF-6EB0-484E-BED1-BE19F1823F42}"/>
          </ac:spMkLst>
        </pc:spChg>
        <pc:spChg chg="add del mod">
          <ac:chgData name="Sami Elamin Mustafa Mohammed" userId="3bc523f75e54a6a4" providerId="LiveId" clId="{B3078D4E-DAAB-47E5-BFF3-560C5FEEC4EA}" dt="2021-11-07T23:15:34.151" v="3576" actId="21"/>
          <ac:spMkLst>
            <pc:docMk/>
            <pc:sldMk cId="81758461" sldId="260"/>
            <ac:spMk id="20" creationId="{483C9132-937B-48E8-977B-1CF513C28304}"/>
          </ac:spMkLst>
        </pc:spChg>
        <pc:spChg chg="add del mod">
          <ac:chgData name="Sami Elamin Mustafa Mohammed" userId="3bc523f75e54a6a4" providerId="LiveId" clId="{B3078D4E-DAAB-47E5-BFF3-560C5FEEC4EA}" dt="2021-11-07T23:15:34.151" v="3576" actId="21"/>
          <ac:spMkLst>
            <pc:docMk/>
            <pc:sldMk cId="81758461" sldId="260"/>
            <ac:spMk id="22" creationId="{70B745B7-CA99-4704-B543-BC9330870CCE}"/>
          </ac:spMkLst>
        </pc:spChg>
        <pc:spChg chg="add del mod">
          <ac:chgData name="Sami Elamin Mustafa Mohammed" userId="3bc523f75e54a6a4" providerId="LiveId" clId="{B3078D4E-DAAB-47E5-BFF3-560C5FEEC4EA}" dt="2021-11-07T23:15:34.151" v="3576" actId="21"/>
          <ac:spMkLst>
            <pc:docMk/>
            <pc:sldMk cId="81758461" sldId="260"/>
            <ac:spMk id="23" creationId="{921CF1C5-6BE7-4EBB-9052-73E3241A4A0C}"/>
          </ac:spMkLst>
        </pc:spChg>
        <pc:spChg chg="add mod">
          <ac:chgData name="Sami Elamin Mustafa Mohammed" userId="3bc523f75e54a6a4" providerId="LiveId" clId="{B3078D4E-DAAB-47E5-BFF3-560C5FEEC4EA}" dt="2021-11-07T23:13:59.843" v="3558" actId="1035"/>
          <ac:spMkLst>
            <pc:docMk/>
            <pc:sldMk cId="81758461" sldId="260"/>
            <ac:spMk id="24" creationId="{0FB68BC1-BAA8-4CF5-83B9-A8F629254CD1}"/>
          </ac:spMkLst>
        </pc:spChg>
        <pc:spChg chg="add mod">
          <ac:chgData name="Sami Elamin Mustafa Mohammed" userId="3bc523f75e54a6a4" providerId="LiveId" clId="{B3078D4E-DAAB-47E5-BFF3-560C5FEEC4EA}" dt="2021-11-07T23:14:19.653" v="3564" actId="555"/>
          <ac:spMkLst>
            <pc:docMk/>
            <pc:sldMk cId="81758461" sldId="260"/>
            <ac:spMk id="25" creationId="{DCDF6C64-CEA4-4A97-BD80-AC23AD4C4A47}"/>
          </ac:spMkLst>
        </pc:spChg>
        <pc:spChg chg="add mod">
          <ac:chgData name="Sami Elamin Mustafa Mohammed" userId="3bc523f75e54a6a4" providerId="LiveId" clId="{B3078D4E-DAAB-47E5-BFF3-560C5FEEC4EA}" dt="2021-11-07T23:14:19.653" v="3564" actId="555"/>
          <ac:spMkLst>
            <pc:docMk/>
            <pc:sldMk cId="81758461" sldId="260"/>
            <ac:spMk id="26" creationId="{08496910-397E-4021-A49E-8BAF392C5FE0}"/>
          </ac:spMkLst>
        </pc:spChg>
        <pc:spChg chg="add mod">
          <ac:chgData name="Sami Elamin Mustafa Mohammed" userId="3bc523f75e54a6a4" providerId="LiveId" clId="{B3078D4E-DAAB-47E5-BFF3-560C5FEEC4EA}" dt="2021-11-07T23:14:19.653" v="3564" actId="555"/>
          <ac:spMkLst>
            <pc:docMk/>
            <pc:sldMk cId="81758461" sldId="260"/>
            <ac:spMk id="27" creationId="{5F2C39FE-C270-4DBF-9FE8-3830B50FA48D}"/>
          </ac:spMkLst>
        </pc:spChg>
        <pc:spChg chg="add del">
          <ac:chgData name="Sami Elamin Mustafa Mohammed" userId="3bc523f75e54a6a4" providerId="LiveId" clId="{B3078D4E-DAAB-47E5-BFF3-560C5FEEC4EA}" dt="2021-11-07T23:15:34.151" v="3576" actId="21"/>
          <ac:spMkLst>
            <pc:docMk/>
            <pc:sldMk cId="81758461" sldId="260"/>
            <ac:spMk id="29" creationId="{9C6A06ED-3ECA-4D13-AF69-3E83D7221F24}"/>
          </ac:spMkLst>
        </pc:spChg>
        <pc:picChg chg="add del">
          <ac:chgData name="Sami Elamin Mustafa Mohammed" userId="3bc523f75e54a6a4" providerId="LiveId" clId="{B3078D4E-DAAB-47E5-BFF3-560C5FEEC4EA}" dt="2021-11-07T23:15:34.151" v="3576" actId="21"/>
          <ac:picMkLst>
            <pc:docMk/>
            <pc:sldMk cId="81758461" sldId="260"/>
            <ac:picMk id="4" creationId="{0C71799E-5620-4E3C-B11D-8ECB9569E769}"/>
          </ac:picMkLst>
        </pc:picChg>
        <pc:picChg chg="del">
          <ac:chgData name="Sami Elamin Mustafa Mohammed" userId="3bc523f75e54a6a4" providerId="LiveId" clId="{B3078D4E-DAAB-47E5-BFF3-560C5FEEC4EA}" dt="2021-11-07T14:01:41.115" v="1322" actId="478"/>
          <ac:picMkLst>
            <pc:docMk/>
            <pc:sldMk cId="81758461" sldId="260"/>
            <ac:picMk id="6" creationId="{8B49611F-3F19-4F0D-94FE-696A5A5BB077}"/>
          </ac:picMkLst>
        </pc:picChg>
        <pc:picChg chg="add mod">
          <ac:chgData name="Sami Elamin Mustafa Mohammed" userId="3bc523f75e54a6a4" providerId="LiveId" clId="{B3078D4E-DAAB-47E5-BFF3-560C5FEEC4EA}" dt="2021-11-07T23:12:37.733" v="3130" actId="14100"/>
          <ac:picMkLst>
            <pc:docMk/>
            <pc:sldMk cId="81758461" sldId="260"/>
            <ac:picMk id="16" creationId="{807317BD-33E8-4485-A882-1B7B4B9BE9BF}"/>
          </ac:picMkLst>
        </pc:picChg>
        <pc:cxnChg chg="del">
          <ac:chgData name="Sami Elamin Mustafa Mohammed" userId="3bc523f75e54a6a4" providerId="LiveId" clId="{B3078D4E-DAAB-47E5-BFF3-560C5FEEC4EA}" dt="2021-11-07T14:01:46.414" v="1325" actId="478"/>
          <ac:cxnSpMkLst>
            <pc:docMk/>
            <pc:sldMk cId="81758461" sldId="260"/>
            <ac:cxnSpMk id="21" creationId="{2E24AF33-FE96-4D70-A937-48328417FFE2}"/>
          </ac:cxnSpMkLst>
        </pc:cxnChg>
      </pc:sldChg>
      <pc:sldChg chg="addSp delSp modSp mod">
        <pc:chgData name="Sami Elamin Mustafa Mohammed" userId="3bc523f75e54a6a4" providerId="LiveId" clId="{B3078D4E-DAAB-47E5-BFF3-560C5FEEC4EA}" dt="2021-11-07T23:14:54.413" v="3572" actId="21"/>
        <pc:sldMkLst>
          <pc:docMk/>
          <pc:sldMk cId="984678245" sldId="262"/>
        </pc:sldMkLst>
        <pc:spChg chg="del mod">
          <ac:chgData name="Sami Elamin Mustafa Mohammed" userId="3bc523f75e54a6a4" providerId="LiveId" clId="{B3078D4E-DAAB-47E5-BFF3-560C5FEEC4EA}" dt="2021-11-07T23:14:54.413" v="3572" actId="21"/>
          <ac:spMkLst>
            <pc:docMk/>
            <pc:sldMk cId="984678245" sldId="262"/>
            <ac:spMk id="2" creationId="{FAB3F805-8A7B-437A-9393-374268D164D4}"/>
          </ac:spMkLst>
        </pc:spChg>
        <pc:spChg chg="del">
          <ac:chgData name="Sami Elamin Mustafa Mohammed" userId="3bc523f75e54a6a4" providerId="LiveId" clId="{B3078D4E-DAAB-47E5-BFF3-560C5FEEC4EA}" dt="2021-11-07T14:01:36.138" v="1321" actId="478"/>
          <ac:spMkLst>
            <pc:docMk/>
            <pc:sldMk cId="984678245" sldId="262"/>
            <ac:spMk id="3" creationId="{B55B1AC8-75E3-4611-851C-3D05F8D86DF3}"/>
          </ac:spMkLst>
        </pc:spChg>
        <pc:spChg chg="del mod">
          <ac:chgData name="Sami Elamin Mustafa Mohammed" userId="3bc523f75e54a6a4" providerId="LiveId" clId="{B3078D4E-DAAB-47E5-BFF3-560C5FEEC4EA}" dt="2021-11-07T23:06:50.567" v="1418" actId="478"/>
          <ac:spMkLst>
            <pc:docMk/>
            <pc:sldMk cId="984678245" sldId="262"/>
            <ac:spMk id="6" creationId="{DFC20FDE-4E23-4F8A-B9DE-38D55F8A8985}"/>
          </ac:spMkLst>
        </pc:spChg>
        <pc:spChg chg="del">
          <ac:chgData name="Sami Elamin Mustafa Mohammed" userId="3bc523f75e54a6a4" providerId="LiveId" clId="{B3078D4E-DAAB-47E5-BFF3-560C5FEEC4EA}" dt="2021-11-07T14:01:16.313" v="1319" actId="478"/>
          <ac:spMkLst>
            <pc:docMk/>
            <pc:sldMk cId="984678245" sldId="262"/>
            <ac:spMk id="7" creationId="{6BE0722A-1B9E-4ED8-9250-533F810F70C4}"/>
          </ac:spMkLst>
        </pc:spChg>
        <pc:spChg chg="mod">
          <ac:chgData name="Sami Elamin Mustafa Mohammed" userId="3bc523f75e54a6a4" providerId="LiveId" clId="{B3078D4E-DAAB-47E5-BFF3-560C5FEEC4EA}" dt="2021-11-07T23:07:47.420" v="1558" actId="1036"/>
          <ac:spMkLst>
            <pc:docMk/>
            <pc:sldMk cId="984678245" sldId="262"/>
            <ac:spMk id="8" creationId="{23C9E54D-5C5B-4926-A769-7A6216045318}"/>
          </ac:spMkLst>
        </pc:spChg>
        <pc:spChg chg="del">
          <ac:chgData name="Sami Elamin Mustafa Mohammed" userId="3bc523f75e54a6a4" providerId="LiveId" clId="{B3078D4E-DAAB-47E5-BFF3-560C5FEEC4EA}" dt="2021-11-07T14:01:23.327" v="1320" actId="478"/>
          <ac:spMkLst>
            <pc:docMk/>
            <pc:sldMk cId="984678245" sldId="262"/>
            <ac:spMk id="11" creationId="{CE26BA62-7626-49F3-A093-39E4512BAE30}"/>
          </ac:spMkLst>
        </pc:spChg>
        <pc:spChg chg="del mod">
          <ac:chgData name="Sami Elamin Mustafa Mohammed" userId="3bc523f75e54a6a4" providerId="LiveId" clId="{B3078D4E-DAAB-47E5-BFF3-560C5FEEC4EA}" dt="2021-11-07T23:14:54.413" v="3572" actId="21"/>
          <ac:spMkLst>
            <pc:docMk/>
            <pc:sldMk cId="984678245" sldId="262"/>
            <ac:spMk id="12" creationId="{85584F14-BEE7-4203-86A6-3E62E060E0BD}"/>
          </ac:spMkLst>
        </pc:spChg>
        <pc:spChg chg="add mod">
          <ac:chgData name="Sami Elamin Mustafa Mohammed" userId="3bc523f75e54a6a4" providerId="LiveId" clId="{B3078D4E-DAAB-47E5-BFF3-560C5FEEC4EA}" dt="2021-11-07T23:07:47.420" v="1558" actId="1036"/>
          <ac:spMkLst>
            <pc:docMk/>
            <pc:sldMk cId="984678245" sldId="262"/>
            <ac:spMk id="14" creationId="{DDB42B73-954D-4A26-9923-5A3B6494A5BA}"/>
          </ac:spMkLst>
        </pc:spChg>
        <pc:spChg chg="add mod">
          <ac:chgData name="Sami Elamin Mustafa Mohammed" userId="3bc523f75e54a6a4" providerId="LiveId" clId="{B3078D4E-DAAB-47E5-BFF3-560C5FEEC4EA}" dt="2021-11-07T23:08:23.712" v="1751" actId="1038"/>
          <ac:spMkLst>
            <pc:docMk/>
            <pc:sldMk cId="984678245" sldId="262"/>
            <ac:spMk id="15" creationId="{27F3AFF2-7F27-4A69-907C-C8451ED2A56E}"/>
          </ac:spMkLst>
        </pc:spChg>
        <pc:spChg chg="add mod">
          <ac:chgData name="Sami Elamin Mustafa Mohammed" userId="3bc523f75e54a6a4" providerId="LiveId" clId="{B3078D4E-DAAB-47E5-BFF3-560C5FEEC4EA}" dt="2021-11-07T23:09:34.329" v="2063" actId="555"/>
          <ac:spMkLst>
            <pc:docMk/>
            <pc:sldMk cId="984678245" sldId="262"/>
            <ac:spMk id="16" creationId="{6662BE42-949C-4B0A-A380-B13CDD03E803}"/>
          </ac:spMkLst>
        </pc:spChg>
        <pc:spChg chg="add mod">
          <ac:chgData name="Sami Elamin Mustafa Mohammed" userId="3bc523f75e54a6a4" providerId="LiveId" clId="{B3078D4E-DAAB-47E5-BFF3-560C5FEEC4EA}" dt="2021-11-07T23:09:34.329" v="2063" actId="555"/>
          <ac:spMkLst>
            <pc:docMk/>
            <pc:sldMk cId="984678245" sldId="262"/>
            <ac:spMk id="17" creationId="{27BCD4D1-6079-43DB-AC0F-958C331C3CE5}"/>
          </ac:spMkLst>
        </pc:spChg>
        <pc:spChg chg="add mod">
          <ac:chgData name="Sami Elamin Mustafa Mohammed" userId="3bc523f75e54a6a4" providerId="LiveId" clId="{B3078D4E-DAAB-47E5-BFF3-560C5FEEC4EA}" dt="2021-11-07T23:09:34.329" v="2063" actId="555"/>
          <ac:spMkLst>
            <pc:docMk/>
            <pc:sldMk cId="984678245" sldId="262"/>
            <ac:spMk id="18" creationId="{A9B17832-D576-498F-AEFF-B1A5B505D3F0}"/>
          </ac:spMkLst>
        </pc:spChg>
        <pc:spChg chg="add del mod">
          <ac:chgData name="Sami Elamin Mustafa Mohammed" userId="3bc523f75e54a6a4" providerId="LiveId" clId="{B3078D4E-DAAB-47E5-BFF3-560C5FEEC4EA}" dt="2021-11-07T23:14:54.413" v="3572" actId="21"/>
          <ac:spMkLst>
            <pc:docMk/>
            <pc:sldMk cId="984678245" sldId="262"/>
            <ac:spMk id="19" creationId="{0CB0F59F-BF1F-4866-91B1-AE8B973C796D}"/>
          </ac:spMkLst>
        </pc:spChg>
        <pc:spChg chg="add del mod">
          <ac:chgData name="Sami Elamin Mustafa Mohammed" userId="3bc523f75e54a6a4" providerId="LiveId" clId="{B3078D4E-DAAB-47E5-BFF3-560C5FEEC4EA}" dt="2021-11-07T23:14:54.413" v="3572" actId="21"/>
          <ac:spMkLst>
            <pc:docMk/>
            <pc:sldMk cId="984678245" sldId="262"/>
            <ac:spMk id="20" creationId="{E1124B5D-C69B-4B0A-9CF2-E6B71A4F8A91}"/>
          </ac:spMkLst>
        </pc:spChg>
        <pc:spChg chg="add del mod">
          <ac:chgData name="Sami Elamin Mustafa Mohammed" userId="3bc523f75e54a6a4" providerId="LiveId" clId="{B3078D4E-DAAB-47E5-BFF3-560C5FEEC4EA}" dt="2021-11-07T23:14:54.413" v="3572" actId="21"/>
          <ac:spMkLst>
            <pc:docMk/>
            <pc:sldMk cId="984678245" sldId="262"/>
            <ac:spMk id="21" creationId="{072A43C0-FE1F-44D8-9C53-8A7D2165A0C7}"/>
          </ac:spMkLst>
        </pc:spChg>
        <pc:spChg chg="add del mod">
          <ac:chgData name="Sami Elamin Mustafa Mohammed" userId="3bc523f75e54a6a4" providerId="LiveId" clId="{B3078D4E-DAAB-47E5-BFF3-560C5FEEC4EA}" dt="2021-11-07T23:14:54.413" v="3572" actId="21"/>
          <ac:spMkLst>
            <pc:docMk/>
            <pc:sldMk cId="984678245" sldId="262"/>
            <ac:spMk id="22" creationId="{65789769-AD81-42A6-8F95-52E37F8D44F5}"/>
          </ac:spMkLst>
        </pc:spChg>
        <pc:picChg chg="del">
          <ac:chgData name="Sami Elamin Mustafa Mohammed" userId="3bc523f75e54a6a4" providerId="LiveId" clId="{B3078D4E-DAAB-47E5-BFF3-560C5FEEC4EA}" dt="2021-11-07T14:01:13.583" v="1318" actId="478"/>
          <ac:picMkLst>
            <pc:docMk/>
            <pc:sldMk cId="984678245" sldId="262"/>
            <ac:picMk id="5" creationId="{75AF8B8D-3360-484A-8D9C-047825D35590}"/>
          </ac:picMkLst>
        </pc:picChg>
        <pc:picChg chg="del mod">
          <ac:chgData name="Sami Elamin Mustafa Mohammed" userId="3bc523f75e54a6a4" providerId="LiveId" clId="{B3078D4E-DAAB-47E5-BFF3-560C5FEEC4EA}" dt="2021-11-07T23:14:54.413" v="3572" actId="21"/>
          <ac:picMkLst>
            <pc:docMk/>
            <pc:sldMk cId="984678245" sldId="262"/>
            <ac:picMk id="10" creationId="{36846B5C-A29B-494B-9D00-5F21F2F05D04}"/>
          </ac:picMkLst>
        </pc:picChg>
        <pc:picChg chg="add mod">
          <ac:chgData name="Sami Elamin Mustafa Mohammed" userId="3bc523f75e54a6a4" providerId="LiveId" clId="{B3078D4E-DAAB-47E5-BFF3-560C5FEEC4EA}" dt="2021-11-07T23:07:47.420" v="1558" actId="1036"/>
          <ac:picMkLst>
            <pc:docMk/>
            <pc:sldMk cId="984678245" sldId="262"/>
            <ac:picMk id="13" creationId="{893AABE6-4AA8-48EC-8A88-5C71293AB204}"/>
          </ac:picMkLst>
        </pc:picChg>
      </pc:sldChg>
      <pc:sldChg chg="addSp delSp modSp mod ord">
        <pc:chgData name="Sami Elamin Mustafa Mohammed" userId="3bc523f75e54a6a4" providerId="LiveId" clId="{B3078D4E-DAAB-47E5-BFF3-560C5FEEC4EA}" dt="2021-11-07T23:11:39.982" v="2952" actId="1038"/>
        <pc:sldMkLst>
          <pc:docMk/>
          <pc:sldMk cId="184709006" sldId="263"/>
        </pc:sldMkLst>
        <pc:spChg chg="del">
          <ac:chgData name="Sami Elamin Mustafa Mohammed" userId="3bc523f75e54a6a4" providerId="LiveId" clId="{B3078D4E-DAAB-47E5-BFF3-560C5FEEC4EA}" dt="2021-11-07T13:54:02.573" v="366" actId="478"/>
          <ac:spMkLst>
            <pc:docMk/>
            <pc:sldMk cId="184709006" sldId="263"/>
            <ac:spMk id="6" creationId="{2C73E03B-2B3C-4163-9EEA-E1BC55769FD8}"/>
          </ac:spMkLst>
        </pc:spChg>
        <pc:spChg chg="mod">
          <ac:chgData name="Sami Elamin Mustafa Mohammed" userId="3bc523f75e54a6a4" providerId="LiveId" clId="{B3078D4E-DAAB-47E5-BFF3-560C5FEEC4EA}" dt="2021-11-07T23:11:39.982" v="2952" actId="1038"/>
          <ac:spMkLst>
            <pc:docMk/>
            <pc:sldMk cId="184709006" sldId="263"/>
            <ac:spMk id="10" creationId="{3512E824-E9C7-4453-8268-ED8C46B7EB1A}"/>
          </ac:spMkLst>
        </pc:spChg>
        <pc:spChg chg="mod">
          <ac:chgData name="Sami Elamin Mustafa Mohammed" userId="3bc523f75e54a6a4" providerId="LiveId" clId="{B3078D4E-DAAB-47E5-BFF3-560C5FEEC4EA}" dt="2021-11-07T23:11:39.982" v="2952" actId="1038"/>
          <ac:spMkLst>
            <pc:docMk/>
            <pc:sldMk cId="184709006" sldId="263"/>
            <ac:spMk id="11" creationId="{3839D61D-D8F3-44CB-B8CB-AFB3B3E1B44F}"/>
          </ac:spMkLst>
        </pc:spChg>
        <pc:spChg chg="mod">
          <ac:chgData name="Sami Elamin Mustafa Mohammed" userId="3bc523f75e54a6a4" providerId="LiveId" clId="{B3078D4E-DAAB-47E5-BFF3-560C5FEEC4EA}" dt="2021-11-07T23:11:39.982" v="2952" actId="1038"/>
          <ac:spMkLst>
            <pc:docMk/>
            <pc:sldMk cId="184709006" sldId="263"/>
            <ac:spMk id="12" creationId="{B47B6190-B273-44BB-9095-0FCF25AEB05A}"/>
          </ac:spMkLst>
        </pc:spChg>
        <pc:spChg chg="del">
          <ac:chgData name="Sami Elamin Mustafa Mohammed" userId="3bc523f75e54a6a4" providerId="LiveId" clId="{B3078D4E-DAAB-47E5-BFF3-560C5FEEC4EA}" dt="2021-11-07T13:52:19.036" v="32" actId="478"/>
          <ac:spMkLst>
            <pc:docMk/>
            <pc:sldMk cId="184709006" sldId="263"/>
            <ac:spMk id="13" creationId="{00000000-0000-0000-0000-000000000000}"/>
          </ac:spMkLst>
        </pc:spChg>
        <pc:spChg chg="add mod">
          <ac:chgData name="Sami Elamin Mustafa Mohammed" userId="3bc523f75e54a6a4" providerId="LiveId" clId="{B3078D4E-DAAB-47E5-BFF3-560C5FEEC4EA}" dt="2021-11-07T23:11:39.982" v="2952" actId="1038"/>
          <ac:spMkLst>
            <pc:docMk/>
            <pc:sldMk cId="184709006" sldId="263"/>
            <ac:spMk id="14" creationId="{8A2AF974-1EBA-44CD-ABAC-BCB673F74BE5}"/>
          </ac:spMkLst>
        </pc:spChg>
        <pc:spChg chg="add mod">
          <ac:chgData name="Sami Elamin Mustafa Mohammed" userId="3bc523f75e54a6a4" providerId="LiveId" clId="{B3078D4E-DAAB-47E5-BFF3-560C5FEEC4EA}" dt="2021-11-07T23:11:39.982" v="2952" actId="1038"/>
          <ac:spMkLst>
            <pc:docMk/>
            <pc:sldMk cId="184709006" sldId="263"/>
            <ac:spMk id="15" creationId="{10A9CB85-801D-4327-8BE1-E0606F945097}"/>
          </ac:spMkLst>
        </pc:spChg>
        <pc:spChg chg="add mod">
          <ac:chgData name="Sami Elamin Mustafa Mohammed" userId="3bc523f75e54a6a4" providerId="LiveId" clId="{B3078D4E-DAAB-47E5-BFF3-560C5FEEC4EA}" dt="2021-11-07T23:11:39.982" v="2952" actId="1038"/>
          <ac:spMkLst>
            <pc:docMk/>
            <pc:sldMk cId="184709006" sldId="263"/>
            <ac:spMk id="16" creationId="{5AD2E01F-22C6-4268-84C8-3392E6320DD1}"/>
          </ac:spMkLst>
        </pc:spChg>
        <pc:spChg chg="add mod">
          <ac:chgData name="Sami Elamin Mustafa Mohammed" userId="3bc523f75e54a6a4" providerId="LiveId" clId="{B3078D4E-DAAB-47E5-BFF3-560C5FEEC4EA}" dt="2021-11-07T23:11:39.982" v="2952" actId="1038"/>
          <ac:spMkLst>
            <pc:docMk/>
            <pc:sldMk cId="184709006" sldId="263"/>
            <ac:spMk id="18" creationId="{37261443-5442-4EE3-8DDE-0C5A42047AE1}"/>
          </ac:spMkLst>
        </pc:spChg>
        <pc:spChg chg="add mod">
          <ac:chgData name="Sami Elamin Mustafa Mohammed" userId="3bc523f75e54a6a4" providerId="LiveId" clId="{B3078D4E-DAAB-47E5-BFF3-560C5FEEC4EA}" dt="2021-11-07T13:52:29.762" v="34" actId="571"/>
          <ac:spMkLst>
            <pc:docMk/>
            <pc:sldMk cId="184709006" sldId="263"/>
            <ac:spMk id="19" creationId="{46B31836-DAC3-491F-B2CF-3FDDAA01230A}"/>
          </ac:spMkLst>
        </pc:spChg>
        <pc:spChg chg="add mod">
          <ac:chgData name="Sami Elamin Mustafa Mohammed" userId="3bc523f75e54a6a4" providerId="LiveId" clId="{B3078D4E-DAAB-47E5-BFF3-560C5FEEC4EA}" dt="2021-11-07T13:52:29.762" v="34" actId="571"/>
          <ac:spMkLst>
            <pc:docMk/>
            <pc:sldMk cId="184709006" sldId="263"/>
            <ac:spMk id="21" creationId="{6B417237-CC0A-4C62-9730-0BF6666F8FEC}"/>
          </ac:spMkLst>
        </pc:spChg>
        <pc:spChg chg="add mod">
          <ac:chgData name="Sami Elamin Mustafa Mohammed" userId="3bc523f75e54a6a4" providerId="LiveId" clId="{B3078D4E-DAAB-47E5-BFF3-560C5FEEC4EA}" dt="2021-11-07T13:52:29.762" v="34" actId="571"/>
          <ac:spMkLst>
            <pc:docMk/>
            <pc:sldMk cId="184709006" sldId="263"/>
            <ac:spMk id="23" creationId="{17AB4B14-CA48-45F2-B30F-EF11E5C01EC8}"/>
          </ac:spMkLst>
        </pc:spChg>
        <pc:spChg chg="del">
          <ac:chgData name="Sami Elamin Mustafa Mohammed" userId="3bc523f75e54a6a4" providerId="LiveId" clId="{B3078D4E-DAAB-47E5-BFF3-560C5FEEC4EA}" dt="2021-11-07T13:54:22.683" v="432" actId="21"/>
          <ac:spMkLst>
            <pc:docMk/>
            <pc:sldMk cId="184709006" sldId="263"/>
            <ac:spMk id="24" creationId="{A4BC2006-051E-48DB-96CD-CC244E2A4176}"/>
          </ac:spMkLst>
        </pc:spChg>
        <pc:spChg chg="mod">
          <ac:chgData name="Sami Elamin Mustafa Mohammed" userId="3bc523f75e54a6a4" providerId="LiveId" clId="{B3078D4E-DAAB-47E5-BFF3-560C5FEEC4EA}" dt="2021-11-07T23:11:39.982" v="2952" actId="1038"/>
          <ac:spMkLst>
            <pc:docMk/>
            <pc:sldMk cId="184709006" sldId="263"/>
            <ac:spMk id="25" creationId="{EE2B7CAC-8423-43B4-AD2C-2EF50F107A5E}"/>
          </ac:spMkLst>
        </pc:spChg>
        <pc:spChg chg="add mod">
          <ac:chgData name="Sami Elamin Mustafa Mohammed" userId="3bc523f75e54a6a4" providerId="LiveId" clId="{B3078D4E-DAAB-47E5-BFF3-560C5FEEC4EA}" dt="2021-11-07T13:52:29.762" v="34" actId="571"/>
          <ac:spMkLst>
            <pc:docMk/>
            <pc:sldMk cId="184709006" sldId="263"/>
            <ac:spMk id="26" creationId="{83B68D36-9D02-496D-B912-E99ADA3087C4}"/>
          </ac:spMkLst>
        </pc:spChg>
        <pc:spChg chg="del">
          <ac:chgData name="Sami Elamin Mustafa Mohammed" userId="3bc523f75e54a6a4" providerId="LiveId" clId="{B3078D4E-DAAB-47E5-BFF3-560C5FEEC4EA}" dt="2021-11-07T13:54:22.683" v="432" actId="21"/>
          <ac:spMkLst>
            <pc:docMk/>
            <pc:sldMk cId="184709006" sldId="263"/>
            <ac:spMk id="28" creationId="{DE6CD548-2334-43C9-8C2E-E3E6911674E1}"/>
          </ac:spMkLst>
        </pc:spChg>
        <pc:spChg chg="add del mod">
          <ac:chgData name="Sami Elamin Mustafa Mohammed" userId="3bc523f75e54a6a4" providerId="LiveId" clId="{B3078D4E-DAAB-47E5-BFF3-560C5FEEC4EA}" dt="2021-11-07T23:11:29.604" v="2926"/>
          <ac:spMkLst>
            <pc:docMk/>
            <pc:sldMk cId="184709006" sldId="263"/>
            <ac:spMk id="29" creationId="{DAEBD5D9-C585-4DF7-92C6-54D1B49156BB}"/>
          </ac:spMkLst>
        </pc:spChg>
        <pc:spChg chg="add del mod">
          <ac:chgData name="Sami Elamin Mustafa Mohammed" userId="3bc523f75e54a6a4" providerId="LiveId" clId="{B3078D4E-DAAB-47E5-BFF3-560C5FEEC4EA}" dt="2021-11-07T23:11:29.604" v="2926"/>
          <ac:spMkLst>
            <pc:docMk/>
            <pc:sldMk cId="184709006" sldId="263"/>
            <ac:spMk id="30" creationId="{07ADFB04-ABD9-4A41-9130-3EEE5821D007}"/>
          </ac:spMkLst>
        </pc:spChg>
        <pc:spChg chg="add del mod">
          <ac:chgData name="Sami Elamin Mustafa Mohammed" userId="3bc523f75e54a6a4" providerId="LiveId" clId="{B3078D4E-DAAB-47E5-BFF3-560C5FEEC4EA}" dt="2021-11-07T23:11:29.604" v="2926"/>
          <ac:spMkLst>
            <pc:docMk/>
            <pc:sldMk cId="184709006" sldId="263"/>
            <ac:spMk id="31" creationId="{CFE98AF1-7593-499E-8242-87DE53850C82}"/>
          </ac:spMkLst>
        </pc:spChg>
        <pc:spChg chg="add del mod">
          <ac:chgData name="Sami Elamin Mustafa Mohammed" userId="3bc523f75e54a6a4" providerId="LiveId" clId="{B3078D4E-DAAB-47E5-BFF3-560C5FEEC4EA}" dt="2021-11-07T23:11:29.604" v="2926"/>
          <ac:spMkLst>
            <pc:docMk/>
            <pc:sldMk cId="184709006" sldId="263"/>
            <ac:spMk id="32" creationId="{D55C78A3-DC80-45C0-B35A-1EB6A6E367B5}"/>
          </ac:spMkLst>
        </pc:spChg>
        <pc:spChg chg="add del mod">
          <ac:chgData name="Sami Elamin Mustafa Mohammed" userId="3bc523f75e54a6a4" providerId="LiveId" clId="{B3078D4E-DAAB-47E5-BFF3-560C5FEEC4EA}" dt="2021-11-07T23:11:29.604" v="2926"/>
          <ac:spMkLst>
            <pc:docMk/>
            <pc:sldMk cId="184709006" sldId="263"/>
            <ac:spMk id="33" creationId="{AC34F778-5796-4F4A-B999-3D0A9D1FD5E6}"/>
          </ac:spMkLst>
        </pc:spChg>
        <pc:spChg chg="add del mod">
          <ac:chgData name="Sami Elamin Mustafa Mohammed" userId="3bc523f75e54a6a4" providerId="LiveId" clId="{B3078D4E-DAAB-47E5-BFF3-560C5FEEC4EA}" dt="2021-11-07T23:11:29.604" v="2926"/>
          <ac:spMkLst>
            <pc:docMk/>
            <pc:sldMk cId="184709006" sldId="263"/>
            <ac:spMk id="34" creationId="{FA6E7A11-3302-44DE-8A57-E5E8D44D0464}"/>
          </ac:spMkLst>
        </pc:spChg>
        <pc:picChg chg="del mod">
          <ac:chgData name="Sami Elamin Mustafa Mohammed" userId="3bc523f75e54a6a4" providerId="LiveId" clId="{B3078D4E-DAAB-47E5-BFF3-560C5FEEC4EA}" dt="2021-11-07T13:54:22.683" v="432" actId="21"/>
          <ac:picMkLst>
            <pc:docMk/>
            <pc:sldMk cId="184709006" sldId="263"/>
            <ac:picMk id="17" creationId="{00000000-0000-0000-0000-000000000000}"/>
          </ac:picMkLst>
        </pc:picChg>
        <pc:picChg chg="mod">
          <ac:chgData name="Sami Elamin Mustafa Mohammed" userId="3bc523f75e54a6a4" providerId="LiveId" clId="{B3078D4E-DAAB-47E5-BFF3-560C5FEEC4EA}" dt="2021-11-07T23:11:39.982" v="2952" actId="1038"/>
          <ac:picMkLst>
            <pc:docMk/>
            <pc:sldMk cId="184709006" sldId="263"/>
            <ac:picMk id="20" creationId="{00000000-0000-0000-0000-000000000000}"/>
          </ac:picMkLst>
        </pc:picChg>
        <pc:picChg chg="mod">
          <ac:chgData name="Sami Elamin Mustafa Mohammed" userId="3bc523f75e54a6a4" providerId="LiveId" clId="{B3078D4E-DAAB-47E5-BFF3-560C5FEEC4EA}" dt="2021-11-07T23:11:39.982" v="2952" actId="1038"/>
          <ac:picMkLst>
            <pc:docMk/>
            <pc:sldMk cId="184709006" sldId="263"/>
            <ac:picMk id="22" creationId="{00000000-0000-0000-0000-000000000000}"/>
          </ac:picMkLst>
        </pc:picChg>
        <pc:picChg chg="add del mod">
          <ac:chgData name="Sami Elamin Mustafa Mohammed" userId="3bc523f75e54a6a4" providerId="LiveId" clId="{B3078D4E-DAAB-47E5-BFF3-560C5FEEC4EA}" dt="2021-11-07T23:11:29.604" v="2926"/>
          <ac:picMkLst>
            <pc:docMk/>
            <pc:sldMk cId="184709006" sldId="263"/>
            <ac:picMk id="27" creationId="{DF53A19E-9E9D-46E1-B091-383ED2ABC5EB}"/>
          </ac:picMkLst>
        </pc:picChg>
      </pc:sldChg>
      <pc:sldChg chg="addSp delSp modSp new mod">
        <pc:chgData name="Sami Elamin Mustafa Mohammed" userId="3bc523f75e54a6a4" providerId="LiveId" clId="{B3078D4E-DAAB-47E5-BFF3-560C5FEEC4EA}" dt="2021-11-07T23:15:00.226" v="3574" actId="1076"/>
        <pc:sldMkLst>
          <pc:docMk/>
          <pc:sldMk cId="190146717" sldId="264"/>
        </pc:sldMkLst>
        <pc:spChg chg="add mod">
          <ac:chgData name="Sami Elamin Mustafa Mohammed" userId="3bc523f75e54a6a4" providerId="LiveId" clId="{B3078D4E-DAAB-47E5-BFF3-560C5FEEC4EA}" dt="2021-11-07T23:15:00.226" v="3574" actId="1076"/>
          <ac:spMkLst>
            <pc:docMk/>
            <pc:sldMk cId="190146717" sldId="264"/>
            <ac:spMk id="4" creationId="{364C268D-0EBB-4797-961C-49B1D09B2FFF}"/>
          </ac:spMkLst>
        </pc:spChg>
        <pc:spChg chg="add mod">
          <ac:chgData name="Sami Elamin Mustafa Mohammed" userId="3bc523f75e54a6a4" providerId="LiveId" clId="{B3078D4E-DAAB-47E5-BFF3-560C5FEEC4EA}" dt="2021-11-07T23:15:00.226" v="3574" actId="1076"/>
          <ac:spMkLst>
            <pc:docMk/>
            <pc:sldMk cId="190146717" sldId="264"/>
            <ac:spMk id="5" creationId="{0160E037-3CFC-40CF-83D2-437F8DE2AE52}"/>
          </ac:spMkLst>
        </pc:spChg>
        <pc:spChg chg="add mod">
          <ac:chgData name="Sami Elamin Mustafa Mohammed" userId="3bc523f75e54a6a4" providerId="LiveId" clId="{B3078D4E-DAAB-47E5-BFF3-560C5FEEC4EA}" dt="2021-11-07T23:15:00.226" v="3574" actId="1076"/>
          <ac:spMkLst>
            <pc:docMk/>
            <pc:sldMk cId="190146717" sldId="264"/>
            <ac:spMk id="6" creationId="{611F255F-8387-4B17-BEBA-1EA96104B45C}"/>
          </ac:spMkLst>
        </pc:spChg>
        <pc:spChg chg="add mod">
          <ac:chgData name="Sami Elamin Mustafa Mohammed" userId="3bc523f75e54a6a4" providerId="LiveId" clId="{B3078D4E-DAAB-47E5-BFF3-560C5FEEC4EA}" dt="2021-11-07T23:15:00.226" v="3574" actId="1076"/>
          <ac:spMkLst>
            <pc:docMk/>
            <pc:sldMk cId="190146717" sldId="264"/>
            <ac:spMk id="7" creationId="{EF6F798C-F6AF-4827-9E0F-9DECDC9D78BE}"/>
          </ac:spMkLst>
        </pc:spChg>
        <pc:spChg chg="add mod">
          <ac:chgData name="Sami Elamin Mustafa Mohammed" userId="3bc523f75e54a6a4" providerId="LiveId" clId="{B3078D4E-DAAB-47E5-BFF3-560C5FEEC4EA}" dt="2021-11-07T23:15:00.226" v="3574" actId="1076"/>
          <ac:spMkLst>
            <pc:docMk/>
            <pc:sldMk cId="190146717" sldId="264"/>
            <ac:spMk id="8" creationId="{824B345E-4E90-474B-81FB-865F7460C0B5}"/>
          </ac:spMkLst>
        </pc:spChg>
        <pc:spChg chg="add mod">
          <ac:chgData name="Sami Elamin Mustafa Mohammed" userId="3bc523f75e54a6a4" providerId="LiveId" clId="{B3078D4E-DAAB-47E5-BFF3-560C5FEEC4EA}" dt="2021-11-07T23:15:00.226" v="3574" actId="1076"/>
          <ac:spMkLst>
            <pc:docMk/>
            <pc:sldMk cId="190146717" sldId="264"/>
            <ac:spMk id="9" creationId="{36F8C7C0-B099-4364-BB84-7EEE4C0576DA}"/>
          </ac:spMkLst>
        </pc:spChg>
        <pc:picChg chg="add del mod modCrop">
          <ac:chgData name="Sami Elamin Mustafa Mohammed" userId="3bc523f75e54a6a4" providerId="LiveId" clId="{B3078D4E-DAAB-47E5-BFF3-560C5FEEC4EA}" dt="2021-11-07T23:12:19.993" v="2974" actId="21"/>
          <ac:picMkLst>
            <pc:docMk/>
            <pc:sldMk cId="190146717" sldId="264"/>
            <ac:picMk id="2" creationId="{7684F0EA-FD5B-497D-8CD0-8DCF61649D2D}"/>
          </ac:picMkLst>
        </pc:picChg>
        <pc:picChg chg="add mod">
          <ac:chgData name="Sami Elamin Mustafa Mohammed" userId="3bc523f75e54a6a4" providerId="LiveId" clId="{B3078D4E-DAAB-47E5-BFF3-560C5FEEC4EA}" dt="2021-11-07T23:15:00.226" v="3574" actId="1076"/>
          <ac:picMkLst>
            <pc:docMk/>
            <pc:sldMk cId="190146717" sldId="264"/>
            <ac:picMk id="3" creationId="{5CD16B04-8214-460A-8133-E8810CBFDCE5}"/>
          </ac:picMkLst>
        </pc:picChg>
      </pc:sldChg>
      <pc:sldChg chg="addSp delSp modSp new mod">
        <pc:chgData name="Sami Elamin Mustafa Mohammed" userId="3bc523f75e54a6a4" providerId="LiveId" clId="{B3078D4E-DAAB-47E5-BFF3-560C5FEEC4EA}" dt="2021-11-07T23:11:48.177" v="2973" actId="1036"/>
        <pc:sldMkLst>
          <pc:docMk/>
          <pc:sldMk cId="1385951106" sldId="265"/>
        </pc:sldMkLst>
        <pc:spChg chg="add del mod">
          <ac:chgData name="Sami Elamin Mustafa Mohammed" userId="3bc523f75e54a6a4" providerId="LiveId" clId="{B3078D4E-DAAB-47E5-BFF3-560C5FEEC4EA}" dt="2021-11-07T23:11:48.177" v="2973" actId="1036"/>
          <ac:spMkLst>
            <pc:docMk/>
            <pc:sldMk cId="1385951106" sldId="265"/>
            <ac:spMk id="3" creationId="{F7E726CE-8AA2-4622-AC67-1FA0D80EAE6F}"/>
          </ac:spMkLst>
        </pc:spChg>
        <pc:spChg chg="add del mod">
          <ac:chgData name="Sami Elamin Mustafa Mohammed" userId="3bc523f75e54a6a4" providerId="LiveId" clId="{B3078D4E-DAAB-47E5-BFF3-560C5FEEC4EA}" dt="2021-11-07T23:11:48.177" v="2973" actId="1036"/>
          <ac:spMkLst>
            <pc:docMk/>
            <pc:sldMk cId="1385951106" sldId="265"/>
            <ac:spMk id="4" creationId="{7E581426-F3D9-42AD-B79F-AB3E4A1EB2A2}"/>
          </ac:spMkLst>
        </pc:spChg>
        <pc:spChg chg="add del mod">
          <ac:chgData name="Sami Elamin Mustafa Mohammed" userId="3bc523f75e54a6a4" providerId="LiveId" clId="{B3078D4E-DAAB-47E5-BFF3-560C5FEEC4EA}" dt="2021-11-07T23:11:48.177" v="2973" actId="1036"/>
          <ac:spMkLst>
            <pc:docMk/>
            <pc:sldMk cId="1385951106" sldId="265"/>
            <ac:spMk id="5" creationId="{5DE1EF37-C59C-4398-AB48-963711377761}"/>
          </ac:spMkLst>
        </pc:spChg>
        <pc:spChg chg="add del mod">
          <ac:chgData name="Sami Elamin Mustafa Mohammed" userId="3bc523f75e54a6a4" providerId="LiveId" clId="{B3078D4E-DAAB-47E5-BFF3-560C5FEEC4EA}" dt="2021-11-07T23:11:48.177" v="2973" actId="1036"/>
          <ac:spMkLst>
            <pc:docMk/>
            <pc:sldMk cId="1385951106" sldId="265"/>
            <ac:spMk id="6" creationId="{B04EBDB6-9955-457E-BBA9-141CF23A43A2}"/>
          </ac:spMkLst>
        </pc:spChg>
        <pc:spChg chg="add del mod">
          <ac:chgData name="Sami Elamin Mustafa Mohammed" userId="3bc523f75e54a6a4" providerId="LiveId" clId="{B3078D4E-DAAB-47E5-BFF3-560C5FEEC4EA}" dt="2021-11-07T23:11:48.177" v="2973" actId="1036"/>
          <ac:spMkLst>
            <pc:docMk/>
            <pc:sldMk cId="1385951106" sldId="265"/>
            <ac:spMk id="7" creationId="{BC295EAA-2D79-4F9D-A1DC-D3037A5F56C0}"/>
          </ac:spMkLst>
        </pc:spChg>
        <pc:spChg chg="add del mod">
          <ac:chgData name="Sami Elamin Mustafa Mohammed" userId="3bc523f75e54a6a4" providerId="LiveId" clId="{B3078D4E-DAAB-47E5-BFF3-560C5FEEC4EA}" dt="2021-11-07T23:11:48.177" v="2973" actId="1036"/>
          <ac:spMkLst>
            <pc:docMk/>
            <pc:sldMk cId="1385951106" sldId="265"/>
            <ac:spMk id="8" creationId="{32F8DC2D-1E26-4980-B88F-84DA8E1FE87F}"/>
          </ac:spMkLst>
        </pc:spChg>
        <pc:spChg chg="add mod">
          <ac:chgData name="Sami Elamin Mustafa Mohammed" userId="3bc523f75e54a6a4" providerId="LiveId" clId="{B3078D4E-DAAB-47E5-BFF3-560C5FEEC4EA}" dt="2021-11-07T23:11:48.177" v="2973" actId="1036"/>
          <ac:spMkLst>
            <pc:docMk/>
            <pc:sldMk cId="1385951106" sldId="265"/>
            <ac:spMk id="11" creationId="{75775941-DBB9-493E-9597-F9B7B606A201}"/>
          </ac:spMkLst>
        </pc:spChg>
        <pc:spChg chg="add mod">
          <ac:chgData name="Sami Elamin Mustafa Mohammed" userId="3bc523f75e54a6a4" providerId="LiveId" clId="{B3078D4E-DAAB-47E5-BFF3-560C5FEEC4EA}" dt="2021-11-07T23:11:48.177" v="2973" actId="1036"/>
          <ac:spMkLst>
            <pc:docMk/>
            <pc:sldMk cId="1385951106" sldId="265"/>
            <ac:spMk id="12" creationId="{DD4535BF-F13A-4159-B201-9A37E5C47B0E}"/>
          </ac:spMkLst>
        </pc:spChg>
        <pc:spChg chg="add mod">
          <ac:chgData name="Sami Elamin Mustafa Mohammed" userId="3bc523f75e54a6a4" providerId="LiveId" clId="{B3078D4E-DAAB-47E5-BFF3-560C5FEEC4EA}" dt="2021-11-07T23:11:48.177" v="2973" actId="1036"/>
          <ac:spMkLst>
            <pc:docMk/>
            <pc:sldMk cId="1385951106" sldId="265"/>
            <ac:spMk id="13" creationId="{F7C4ADD7-49AA-4A25-B65C-20442201AA49}"/>
          </ac:spMkLst>
        </pc:spChg>
        <pc:spChg chg="add mod">
          <ac:chgData name="Sami Elamin Mustafa Mohammed" userId="3bc523f75e54a6a4" providerId="LiveId" clId="{B3078D4E-DAAB-47E5-BFF3-560C5FEEC4EA}" dt="2021-11-07T23:11:48.177" v="2973" actId="1036"/>
          <ac:spMkLst>
            <pc:docMk/>
            <pc:sldMk cId="1385951106" sldId="265"/>
            <ac:spMk id="14" creationId="{7052DBBB-E624-425A-8F9D-C97A6D989618}"/>
          </ac:spMkLst>
        </pc:spChg>
        <pc:spChg chg="add mod">
          <ac:chgData name="Sami Elamin Mustafa Mohammed" userId="3bc523f75e54a6a4" providerId="LiveId" clId="{B3078D4E-DAAB-47E5-BFF3-560C5FEEC4EA}" dt="2021-11-07T23:11:48.177" v="2973" actId="1036"/>
          <ac:spMkLst>
            <pc:docMk/>
            <pc:sldMk cId="1385951106" sldId="265"/>
            <ac:spMk id="15" creationId="{847D8FD7-7277-4576-9371-BC6A1194FE11}"/>
          </ac:spMkLst>
        </pc:spChg>
        <pc:spChg chg="add mod">
          <ac:chgData name="Sami Elamin Mustafa Mohammed" userId="3bc523f75e54a6a4" providerId="LiveId" clId="{B3078D4E-DAAB-47E5-BFF3-560C5FEEC4EA}" dt="2021-11-07T23:11:48.177" v="2973" actId="1036"/>
          <ac:spMkLst>
            <pc:docMk/>
            <pc:sldMk cId="1385951106" sldId="265"/>
            <ac:spMk id="16" creationId="{F3D79E65-3188-466C-A7B6-625067EED52F}"/>
          </ac:spMkLst>
        </pc:spChg>
        <pc:spChg chg="add mod">
          <ac:chgData name="Sami Elamin Mustafa Mohammed" userId="3bc523f75e54a6a4" providerId="LiveId" clId="{B3078D4E-DAAB-47E5-BFF3-560C5FEEC4EA}" dt="2021-11-07T23:11:48.177" v="2973" actId="1036"/>
          <ac:spMkLst>
            <pc:docMk/>
            <pc:sldMk cId="1385951106" sldId="265"/>
            <ac:spMk id="17" creationId="{97420D90-67F1-49A2-B16B-F73D92DEB319}"/>
          </ac:spMkLst>
        </pc:spChg>
        <pc:spChg chg="add mod">
          <ac:chgData name="Sami Elamin Mustafa Mohammed" userId="3bc523f75e54a6a4" providerId="LiveId" clId="{B3078D4E-DAAB-47E5-BFF3-560C5FEEC4EA}" dt="2021-11-07T23:11:48.177" v="2973" actId="1036"/>
          <ac:spMkLst>
            <pc:docMk/>
            <pc:sldMk cId="1385951106" sldId="265"/>
            <ac:spMk id="18" creationId="{3D1C88F4-AA43-40D2-B0E9-54FACCF0A312}"/>
          </ac:spMkLst>
        </pc:spChg>
        <pc:picChg chg="add del mod">
          <ac:chgData name="Sami Elamin Mustafa Mohammed" userId="3bc523f75e54a6a4" providerId="LiveId" clId="{B3078D4E-DAAB-47E5-BFF3-560C5FEEC4EA}" dt="2021-11-07T23:11:48.177" v="2973" actId="1036"/>
          <ac:picMkLst>
            <pc:docMk/>
            <pc:sldMk cId="1385951106" sldId="265"/>
            <ac:picMk id="2" creationId="{00999A70-D63D-431A-88AB-DAC0D08752C3}"/>
          </ac:picMkLst>
        </pc:picChg>
        <pc:picChg chg="add mod">
          <ac:chgData name="Sami Elamin Mustafa Mohammed" userId="3bc523f75e54a6a4" providerId="LiveId" clId="{B3078D4E-DAAB-47E5-BFF3-560C5FEEC4EA}" dt="2021-11-07T23:11:48.177" v="2973" actId="1036"/>
          <ac:picMkLst>
            <pc:docMk/>
            <pc:sldMk cId="1385951106" sldId="265"/>
            <ac:picMk id="10" creationId="{F0EB78D9-5E47-4FCB-A32B-DD52CDCB6FA6}"/>
          </ac:picMkLst>
        </pc:picChg>
        <pc:picChg chg="add del mod">
          <ac:chgData name="Sami Elamin Mustafa Mohammed" userId="3bc523f75e54a6a4" providerId="LiveId" clId="{B3078D4E-DAAB-47E5-BFF3-560C5FEEC4EA}" dt="2021-11-07T23:06:18.796" v="1403" actId="21"/>
          <ac:picMkLst>
            <pc:docMk/>
            <pc:sldMk cId="1385951106" sldId="265"/>
            <ac:picMk id="20" creationId="{800571D7-CA9E-4B4E-A67B-AE5B9D8CD504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1CA742-FD69-455D-A184-0204602727E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T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3426821-71F3-433D-AB09-9A2E2E8E2D0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534E86-619C-4975-B88A-00C6B994A5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9605F-5178-4B08-84D1-9E87C2F1E3C0}" type="datetimeFigureOut">
              <a:rPr lang="en-AT" smtClean="0"/>
              <a:t>07/11/2021</a:t>
            </a:fld>
            <a:endParaRPr lang="en-A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43C444-71D2-47DE-BF4A-7910E4B9C7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E16A83-8885-4FD5-B623-2FC6409275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EA83CC-552D-4B80-AB51-7B8B0C059766}" type="slidenum">
              <a:rPr lang="en-AT" smtClean="0"/>
              <a:t>‹#›</a:t>
            </a:fld>
            <a:endParaRPr lang="en-AT"/>
          </a:p>
        </p:txBody>
      </p:sp>
    </p:spTree>
    <p:extLst>
      <p:ext uri="{BB962C8B-B14F-4D97-AF65-F5344CB8AC3E}">
        <p14:creationId xmlns:p14="http://schemas.microsoft.com/office/powerpoint/2010/main" val="2610929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8F13FA-44A3-48D8-A16A-C0662DF483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T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76C18FC-9B0D-4B7A-B78E-94389A093C8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B02DB8-56FD-4301-AD61-F6BAC67452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9605F-5178-4B08-84D1-9E87C2F1E3C0}" type="datetimeFigureOut">
              <a:rPr lang="en-AT" smtClean="0"/>
              <a:t>07/11/2021</a:t>
            </a:fld>
            <a:endParaRPr lang="en-A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924A81-4FBB-41C4-B016-527420667F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22850A6-722F-46E0-9FD3-C5617CD1CB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EA83CC-552D-4B80-AB51-7B8B0C059766}" type="slidenum">
              <a:rPr lang="en-AT" smtClean="0"/>
              <a:t>‹#›</a:t>
            </a:fld>
            <a:endParaRPr lang="en-AT"/>
          </a:p>
        </p:txBody>
      </p:sp>
    </p:spTree>
    <p:extLst>
      <p:ext uri="{BB962C8B-B14F-4D97-AF65-F5344CB8AC3E}">
        <p14:creationId xmlns:p14="http://schemas.microsoft.com/office/powerpoint/2010/main" val="28077460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1BBC653-084A-4A62-BA71-8D3D8F80E57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T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DC44049-3EA5-4729-A00B-2D785280A93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8DF3C34-F3FC-4301-9774-8EB9A4EB4E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9605F-5178-4B08-84D1-9E87C2F1E3C0}" type="datetimeFigureOut">
              <a:rPr lang="en-AT" smtClean="0"/>
              <a:t>07/11/2021</a:t>
            </a:fld>
            <a:endParaRPr lang="en-A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728F7A-27BE-47E2-A31C-0BC94678FA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3C5E4A-C7A9-4071-B2AD-0DAD31D8E2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EA83CC-552D-4B80-AB51-7B8B0C059766}" type="slidenum">
              <a:rPr lang="en-AT" smtClean="0"/>
              <a:t>‹#›</a:t>
            </a:fld>
            <a:endParaRPr lang="en-AT"/>
          </a:p>
        </p:txBody>
      </p:sp>
    </p:spTree>
    <p:extLst>
      <p:ext uri="{BB962C8B-B14F-4D97-AF65-F5344CB8AC3E}">
        <p14:creationId xmlns:p14="http://schemas.microsoft.com/office/powerpoint/2010/main" val="2795288496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8A865-16B7-475C-9C67-C7187D89DDB4}" type="datetimeFigureOut">
              <a:rPr lang="de-DE" smtClean="0"/>
              <a:t>07.11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18C3D-A931-4D63-92D0-6DA9884F13C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05369502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8A865-16B7-475C-9C67-C7187D89DDB4}" type="datetimeFigureOut">
              <a:rPr lang="de-DE" smtClean="0"/>
              <a:t>07.11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18C3D-A931-4D63-92D0-6DA9884F13C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2436967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8A865-16B7-475C-9C67-C7187D89DDB4}" type="datetimeFigureOut">
              <a:rPr lang="de-DE" smtClean="0"/>
              <a:t>07.11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18C3D-A931-4D63-92D0-6DA9884F13C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74933169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8A865-16B7-475C-9C67-C7187D89DDB4}" type="datetimeFigureOut">
              <a:rPr lang="de-DE" smtClean="0"/>
              <a:t>07.11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18C3D-A931-4D63-92D0-6DA9884F13C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69731329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8A865-16B7-475C-9C67-C7187D89DDB4}" type="datetimeFigureOut">
              <a:rPr lang="de-DE" smtClean="0"/>
              <a:t>07.11.2021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18C3D-A931-4D63-92D0-6DA9884F13C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03685865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8A865-16B7-475C-9C67-C7187D89DDB4}" type="datetimeFigureOut">
              <a:rPr lang="de-DE" smtClean="0"/>
              <a:t>07.11.2021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18C3D-A931-4D63-92D0-6DA9884F13C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96416843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8A865-16B7-475C-9C67-C7187D89DDB4}" type="datetimeFigureOut">
              <a:rPr lang="de-DE" smtClean="0"/>
              <a:t>07.11.2021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18C3D-A931-4D63-92D0-6DA9884F13C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57924263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8A865-16B7-475C-9C67-C7187D89DDB4}" type="datetimeFigureOut">
              <a:rPr lang="de-DE" smtClean="0"/>
              <a:t>07.11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18C3D-A931-4D63-92D0-6DA9884F13C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183848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05EF3D-0CA1-4B3A-911D-C902269AA9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T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AFEEB2D-EB05-487B-82EA-67358FE4AC6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981057-40D7-412E-9FB2-13DC0FF976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9605F-5178-4B08-84D1-9E87C2F1E3C0}" type="datetimeFigureOut">
              <a:rPr lang="en-AT" smtClean="0"/>
              <a:t>07/11/2021</a:t>
            </a:fld>
            <a:endParaRPr lang="en-A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B11B65-E18E-4D6F-AB6F-B908597553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32BEC6-888E-4F77-B73B-F1A38EDC06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EA83CC-552D-4B80-AB51-7B8B0C059766}" type="slidenum">
              <a:rPr lang="en-AT" smtClean="0"/>
              <a:t>‹#›</a:t>
            </a:fld>
            <a:endParaRPr lang="en-AT"/>
          </a:p>
        </p:txBody>
      </p:sp>
    </p:spTree>
    <p:extLst>
      <p:ext uri="{BB962C8B-B14F-4D97-AF65-F5344CB8AC3E}">
        <p14:creationId xmlns:p14="http://schemas.microsoft.com/office/powerpoint/2010/main" val="2649338977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8A865-16B7-475C-9C67-C7187D89DDB4}" type="datetimeFigureOut">
              <a:rPr lang="de-DE" smtClean="0"/>
              <a:t>07.11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18C3D-A931-4D63-92D0-6DA9884F13C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93582217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8A865-16B7-475C-9C67-C7187D89DDB4}" type="datetimeFigureOut">
              <a:rPr lang="de-DE" smtClean="0"/>
              <a:t>07.11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18C3D-A931-4D63-92D0-6DA9884F13C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79343474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8A865-16B7-475C-9C67-C7187D89DDB4}" type="datetimeFigureOut">
              <a:rPr lang="de-DE" smtClean="0"/>
              <a:t>07.11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18C3D-A931-4D63-92D0-6DA9884F13C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275698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0D296A-886A-488F-BF8D-8E3451A0C9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T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E774A5E-9107-4C64-90AA-0DA7EC8E24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BA3D1B-DC63-433F-99C1-EBD04DEDD3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9605F-5178-4B08-84D1-9E87C2F1E3C0}" type="datetimeFigureOut">
              <a:rPr lang="en-AT" smtClean="0"/>
              <a:t>07/11/2021</a:t>
            </a:fld>
            <a:endParaRPr lang="en-A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C62DDF-DF5A-48AD-A2DE-38C1C8AF53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E6B3C9-EA90-4DC8-B361-E6B39BF90D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EA83CC-552D-4B80-AB51-7B8B0C059766}" type="slidenum">
              <a:rPr lang="en-AT" smtClean="0"/>
              <a:t>‹#›</a:t>
            </a:fld>
            <a:endParaRPr lang="en-AT"/>
          </a:p>
        </p:txBody>
      </p:sp>
    </p:spTree>
    <p:extLst>
      <p:ext uri="{BB962C8B-B14F-4D97-AF65-F5344CB8AC3E}">
        <p14:creationId xmlns:p14="http://schemas.microsoft.com/office/powerpoint/2010/main" val="23223354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5F9C88-FACB-4F6C-BA95-E783BEC92D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T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26827B6-BB94-434A-8CFA-9E21CE51DA3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T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575BB22-3B06-4A47-B22A-372884898E6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T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8A14915-D8F3-42CD-ABCC-20A1EF03BB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9605F-5178-4B08-84D1-9E87C2F1E3C0}" type="datetimeFigureOut">
              <a:rPr lang="en-AT" smtClean="0"/>
              <a:t>07/11/2021</a:t>
            </a:fld>
            <a:endParaRPr lang="en-A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B42AA8F-E307-43B1-8DB4-B58A32F5D2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E0916EC-8617-4E01-BCAB-A391DB9A01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EA83CC-552D-4B80-AB51-7B8B0C059766}" type="slidenum">
              <a:rPr lang="en-AT" smtClean="0"/>
              <a:t>‹#›</a:t>
            </a:fld>
            <a:endParaRPr lang="en-AT"/>
          </a:p>
        </p:txBody>
      </p:sp>
    </p:spTree>
    <p:extLst>
      <p:ext uri="{BB962C8B-B14F-4D97-AF65-F5344CB8AC3E}">
        <p14:creationId xmlns:p14="http://schemas.microsoft.com/office/powerpoint/2010/main" val="33224372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AF9ED2-C88F-4150-B326-7F0E4F0760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T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5049E0F-A9FF-4DBC-8A43-360D7AE41C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F20F770-ACC1-4E30-9FBB-E18CC5483D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T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EE6C483-8F7A-45C8-945F-5599767BD56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2EC80D9-4336-464E-9457-06BB10FA8D2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T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AFC5BAD-8672-4B4F-946D-36616CB5BC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9605F-5178-4B08-84D1-9E87C2F1E3C0}" type="datetimeFigureOut">
              <a:rPr lang="en-AT" smtClean="0"/>
              <a:t>07/11/2021</a:t>
            </a:fld>
            <a:endParaRPr lang="en-AT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9261D93-36D0-405B-BB89-B5C2EA1EFE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T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7BC4EB6-333D-4BCE-9E43-757076D375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EA83CC-552D-4B80-AB51-7B8B0C059766}" type="slidenum">
              <a:rPr lang="en-AT" smtClean="0"/>
              <a:t>‹#›</a:t>
            </a:fld>
            <a:endParaRPr lang="en-AT"/>
          </a:p>
        </p:txBody>
      </p:sp>
    </p:spTree>
    <p:extLst>
      <p:ext uri="{BB962C8B-B14F-4D97-AF65-F5344CB8AC3E}">
        <p14:creationId xmlns:p14="http://schemas.microsoft.com/office/powerpoint/2010/main" val="29635976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23108F-16AF-4F44-BF46-CFD17E3BD9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T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D7443A7-B917-4E69-87EF-B7CCBEEE8F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9605F-5178-4B08-84D1-9E87C2F1E3C0}" type="datetimeFigureOut">
              <a:rPr lang="en-AT" smtClean="0"/>
              <a:t>07/11/2021</a:t>
            </a:fld>
            <a:endParaRPr lang="en-AT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3D161CF-4DD8-4154-9176-C4E147BEED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T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8C4A181-C836-4552-9517-8657D38874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EA83CC-552D-4B80-AB51-7B8B0C059766}" type="slidenum">
              <a:rPr lang="en-AT" smtClean="0"/>
              <a:t>‹#›</a:t>
            </a:fld>
            <a:endParaRPr lang="en-AT"/>
          </a:p>
        </p:txBody>
      </p:sp>
    </p:spTree>
    <p:extLst>
      <p:ext uri="{BB962C8B-B14F-4D97-AF65-F5344CB8AC3E}">
        <p14:creationId xmlns:p14="http://schemas.microsoft.com/office/powerpoint/2010/main" val="19886179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E7B5850-1F37-401D-9A8A-2211ED7196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9605F-5178-4B08-84D1-9E87C2F1E3C0}" type="datetimeFigureOut">
              <a:rPr lang="en-AT" smtClean="0"/>
              <a:t>07/11/2021</a:t>
            </a:fld>
            <a:endParaRPr lang="en-AT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CDCBA71-1FBF-4582-A312-E388056C1D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T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4E4AB5C-A4D4-4810-BA28-92009EE8C2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EA83CC-552D-4B80-AB51-7B8B0C059766}" type="slidenum">
              <a:rPr lang="en-AT" smtClean="0"/>
              <a:t>‹#›</a:t>
            </a:fld>
            <a:endParaRPr lang="en-AT"/>
          </a:p>
        </p:txBody>
      </p:sp>
    </p:spTree>
    <p:extLst>
      <p:ext uri="{BB962C8B-B14F-4D97-AF65-F5344CB8AC3E}">
        <p14:creationId xmlns:p14="http://schemas.microsoft.com/office/powerpoint/2010/main" val="22274743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790348-2797-4271-B31C-B3D91283A6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T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D1C812C-94DD-4905-997F-E3E5E794C59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T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E492DBF-00D4-46C4-8C13-D668263AB3F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01B0A20-1D32-4DFB-AEB1-DA2EFCCAF1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9605F-5178-4B08-84D1-9E87C2F1E3C0}" type="datetimeFigureOut">
              <a:rPr lang="en-AT" smtClean="0"/>
              <a:t>07/11/2021</a:t>
            </a:fld>
            <a:endParaRPr lang="en-A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14100E4-1FD2-4BBA-A580-80B47A9FED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1B09719-A863-48BC-BE8F-822385533E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EA83CC-552D-4B80-AB51-7B8B0C059766}" type="slidenum">
              <a:rPr lang="en-AT" smtClean="0"/>
              <a:t>‹#›</a:t>
            </a:fld>
            <a:endParaRPr lang="en-AT"/>
          </a:p>
        </p:txBody>
      </p:sp>
    </p:spTree>
    <p:extLst>
      <p:ext uri="{BB962C8B-B14F-4D97-AF65-F5344CB8AC3E}">
        <p14:creationId xmlns:p14="http://schemas.microsoft.com/office/powerpoint/2010/main" val="30507182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C7BFBA-1A5A-404E-883F-821FDCE2DA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T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D049321-3976-4927-924A-4BE830FF631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T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2D65024-3EF9-47C6-BA12-264D6CC0AC0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FA85BAA-758E-41A4-B256-E1ED925D45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9605F-5178-4B08-84D1-9E87C2F1E3C0}" type="datetimeFigureOut">
              <a:rPr lang="en-AT" smtClean="0"/>
              <a:t>07/11/2021</a:t>
            </a:fld>
            <a:endParaRPr lang="en-A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518DA34-EA0D-4BF6-8441-A93223D798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3DE78A8-E3F0-4325-B1D6-088DF19041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EA83CC-552D-4B80-AB51-7B8B0C059766}" type="slidenum">
              <a:rPr lang="en-AT" smtClean="0"/>
              <a:t>‹#›</a:t>
            </a:fld>
            <a:endParaRPr lang="en-AT"/>
          </a:p>
        </p:txBody>
      </p:sp>
    </p:spTree>
    <p:extLst>
      <p:ext uri="{BB962C8B-B14F-4D97-AF65-F5344CB8AC3E}">
        <p14:creationId xmlns:p14="http://schemas.microsoft.com/office/powerpoint/2010/main" val="21504596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E6B6CD8-D7CC-484B-87CC-70EC3BC885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T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52477A9-696B-4A4F-A890-7BFBBE17C0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DD4A77-983C-474F-BCC1-52ADC498063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B9605F-5178-4B08-84D1-9E87C2F1E3C0}" type="datetimeFigureOut">
              <a:rPr lang="en-AT" smtClean="0"/>
              <a:t>07/11/2021</a:t>
            </a:fld>
            <a:endParaRPr lang="en-A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5C5A951-D8EB-40E4-9DED-B9A7F2C03FC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F652EE-F2A7-45AE-B409-BBB254F05AC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EA83CC-552D-4B80-AB51-7B8B0C059766}" type="slidenum">
              <a:rPr lang="en-AT" smtClean="0"/>
              <a:t>‹#›</a:t>
            </a:fld>
            <a:endParaRPr lang="en-AT"/>
          </a:p>
        </p:txBody>
      </p:sp>
    </p:spTree>
    <p:extLst>
      <p:ext uri="{BB962C8B-B14F-4D97-AF65-F5344CB8AC3E}">
        <p14:creationId xmlns:p14="http://schemas.microsoft.com/office/powerpoint/2010/main" val="39231008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A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98A865-16B7-475C-9C67-C7187D89DDB4}" type="datetimeFigureOut">
              <a:rPr lang="de-DE" smtClean="0"/>
              <a:t>07.11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E18C3D-A931-4D63-92D0-6DA9884F13C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853646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3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Grafik 19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37532" y="3650144"/>
            <a:ext cx="3816000" cy="2631275"/>
          </a:xfrm>
          <a:prstGeom prst="rect">
            <a:avLst/>
          </a:prstGeom>
        </p:spPr>
      </p:pic>
      <p:pic>
        <p:nvPicPr>
          <p:cNvPr id="22" name="Grafik 2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47947" y="735053"/>
            <a:ext cx="3805585" cy="2520000"/>
          </a:xfrm>
          <a:prstGeom prst="rect">
            <a:avLst/>
          </a:prstGeom>
        </p:spPr>
      </p:pic>
      <p:sp>
        <p:nvSpPr>
          <p:cNvPr id="10" name="Rectangle 9">
            <a:extLst>
              <a:ext uri="{FF2B5EF4-FFF2-40B4-BE49-F238E27FC236}">
                <a16:creationId xmlns:a16="http://schemas.microsoft.com/office/drawing/2014/main" id="{3512E824-E9C7-4453-8268-ED8C46B7EB1A}"/>
              </a:ext>
            </a:extLst>
          </p:cNvPr>
          <p:cNvSpPr/>
          <p:nvPr/>
        </p:nvSpPr>
        <p:spPr>
          <a:xfrm>
            <a:off x="1947947" y="2141607"/>
            <a:ext cx="3498984" cy="41490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EE2B7CAC-8423-43B4-AD2C-2EF50F107A5E}"/>
              </a:ext>
            </a:extLst>
          </p:cNvPr>
          <p:cNvSpPr/>
          <p:nvPr/>
        </p:nvSpPr>
        <p:spPr>
          <a:xfrm>
            <a:off x="1947947" y="3871054"/>
            <a:ext cx="3576803" cy="51380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839D61D-D8F3-44CB-B8CB-AFB3B3E1B44F}"/>
              </a:ext>
            </a:extLst>
          </p:cNvPr>
          <p:cNvSpPr txBox="1"/>
          <p:nvPr/>
        </p:nvSpPr>
        <p:spPr>
          <a:xfrm>
            <a:off x="896764" y="2147994"/>
            <a:ext cx="10189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>
                <a:solidFill>
                  <a:prstClr val="black"/>
                </a:solidFill>
                <a:latin typeface="Calibri" panose="020F0502020204030204"/>
              </a:rPr>
              <a:t>MICS1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47B6190-B273-44BB-9095-0FCF25AEB05A}"/>
              </a:ext>
            </a:extLst>
          </p:cNvPr>
          <p:cNvSpPr txBox="1"/>
          <p:nvPr/>
        </p:nvSpPr>
        <p:spPr>
          <a:xfrm>
            <a:off x="911899" y="3963964"/>
            <a:ext cx="13977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LETM1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A2AF974-1EBA-44CD-ABAC-BCB673F74BE5}"/>
              </a:ext>
            </a:extLst>
          </p:cNvPr>
          <p:cNvSpPr txBox="1"/>
          <p:nvPr/>
        </p:nvSpPr>
        <p:spPr>
          <a:xfrm>
            <a:off x="2019727" y="415476"/>
            <a:ext cx="33041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WT  #1  #2  WT  #1  #2  WT #2 #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0A9CB85-801D-4327-8BE1-E0606F945097}"/>
              </a:ext>
            </a:extLst>
          </p:cNvPr>
          <p:cNvSpPr txBox="1"/>
          <p:nvPr/>
        </p:nvSpPr>
        <p:spPr>
          <a:xfrm>
            <a:off x="2681535" y="113323"/>
            <a:ext cx="6274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B" sz="160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AD2E01F-22C6-4268-84C8-3392E6320DD1}"/>
              </a:ext>
            </a:extLst>
          </p:cNvPr>
          <p:cNvSpPr txBox="1"/>
          <p:nvPr/>
        </p:nvSpPr>
        <p:spPr>
          <a:xfrm>
            <a:off x="4691365" y="113323"/>
            <a:ext cx="56350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B" sz="160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7261443-5442-4EE3-8DDE-0C5A42047AE1}"/>
              </a:ext>
            </a:extLst>
          </p:cNvPr>
          <p:cNvSpPr txBox="1"/>
          <p:nvPr/>
        </p:nvSpPr>
        <p:spPr>
          <a:xfrm>
            <a:off x="3701608" y="113323"/>
            <a:ext cx="56350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B" sz="160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</a:p>
        </p:txBody>
      </p:sp>
    </p:spTree>
    <p:extLst>
      <p:ext uri="{BB962C8B-B14F-4D97-AF65-F5344CB8AC3E}">
        <p14:creationId xmlns:p14="http://schemas.microsoft.com/office/powerpoint/2010/main" val="1847090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6">
            <a:extLst>
              <a:ext uri="{FF2B5EF4-FFF2-40B4-BE49-F238E27FC236}">
                <a16:creationId xmlns:a16="http://schemas.microsoft.com/office/drawing/2014/main" id="{00999A70-D63D-431A-88AB-DAC0D08752C3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2032" y="1347396"/>
            <a:ext cx="3886881" cy="2834640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F7E726CE-8AA2-4622-AC67-1FA0D80EAE6F}"/>
              </a:ext>
            </a:extLst>
          </p:cNvPr>
          <p:cNvSpPr/>
          <p:nvPr/>
        </p:nvSpPr>
        <p:spPr>
          <a:xfrm>
            <a:off x="1043328" y="1473920"/>
            <a:ext cx="3651384" cy="51380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E581426-F3D9-42AD-B79F-AB3E4A1EB2A2}"/>
              </a:ext>
            </a:extLst>
          </p:cNvPr>
          <p:cNvSpPr txBox="1"/>
          <p:nvPr/>
        </p:nvSpPr>
        <p:spPr>
          <a:xfrm>
            <a:off x="124599" y="1522987"/>
            <a:ext cx="10279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HSP60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DE1EF37-C59C-4398-AB48-963711377761}"/>
              </a:ext>
            </a:extLst>
          </p:cNvPr>
          <p:cNvSpPr txBox="1"/>
          <p:nvPr/>
        </p:nvSpPr>
        <p:spPr>
          <a:xfrm>
            <a:off x="1193340" y="884901"/>
            <a:ext cx="33041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WT  #1  #2  WT  #1  #2  WT #2 #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04EBDB6-9955-457E-BBA9-141CF23A43A2}"/>
              </a:ext>
            </a:extLst>
          </p:cNvPr>
          <p:cNvSpPr txBox="1"/>
          <p:nvPr/>
        </p:nvSpPr>
        <p:spPr>
          <a:xfrm>
            <a:off x="1855148" y="582748"/>
            <a:ext cx="6274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B" sz="16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C295EAA-2D79-4F9D-A1DC-D3037A5F56C0}"/>
              </a:ext>
            </a:extLst>
          </p:cNvPr>
          <p:cNvSpPr txBox="1"/>
          <p:nvPr/>
        </p:nvSpPr>
        <p:spPr>
          <a:xfrm>
            <a:off x="3864978" y="582748"/>
            <a:ext cx="56350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B" sz="160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2F8DC2D-1E26-4980-B88F-84DA8E1FE87F}"/>
              </a:ext>
            </a:extLst>
          </p:cNvPr>
          <p:cNvSpPr txBox="1"/>
          <p:nvPr/>
        </p:nvSpPr>
        <p:spPr>
          <a:xfrm>
            <a:off x="2875221" y="582748"/>
            <a:ext cx="56350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B" sz="160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F0EB78D9-5E47-4FCB-A32B-DD52CDCB6FA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27209" y="1360369"/>
            <a:ext cx="3915997" cy="3924000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75775941-DBB9-493E-9597-F9B7B606A201}"/>
              </a:ext>
            </a:extLst>
          </p:cNvPr>
          <p:cNvSpPr txBox="1"/>
          <p:nvPr/>
        </p:nvSpPr>
        <p:spPr>
          <a:xfrm>
            <a:off x="6602276" y="875938"/>
            <a:ext cx="34195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WT #1  #2  WT  #1   #2  WT #2   #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D4535BF-F13A-4159-B201-9A37E5C47B0E}"/>
              </a:ext>
            </a:extLst>
          </p:cNvPr>
          <p:cNvSpPr txBox="1"/>
          <p:nvPr/>
        </p:nvSpPr>
        <p:spPr>
          <a:xfrm>
            <a:off x="7264084" y="573785"/>
            <a:ext cx="6274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B" sz="160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7C4ADD7-49AA-4A25-B65C-20442201AA49}"/>
              </a:ext>
            </a:extLst>
          </p:cNvPr>
          <p:cNvSpPr txBox="1"/>
          <p:nvPr/>
        </p:nvSpPr>
        <p:spPr>
          <a:xfrm>
            <a:off x="9273914" y="573785"/>
            <a:ext cx="56350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B" sz="160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052DBBB-E624-425A-8F9D-C97A6D989618}"/>
              </a:ext>
            </a:extLst>
          </p:cNvPr>
          <p:cNvSpPr txBox="1"/>
          <p:nvPr/>
        </p:nvSpPr>
        <p:spPr>
          <a:xfrm>
            <a:off x="8284157" y="573785"/>
            <a:ext cx="56350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B" sz="160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847D8FD7-7277-4576-9371-BC6A1194FE11}"/>
              </a:ext>
            </a:extLst>
          </p:cNvPr>
          <p:cNvSpPr/>
          <p:nvPr/>
        </p:nvSpPr>
        <p:spPr>
          <a:xfrm>
            <a:off x="6530506" y="3675161"/>
            <a:ext cx="3527891" cy="51380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F3D79E65-3188-466C-A7B6-625067EED52F}"/>
              </a:ext>
            </a:extLst>
          </p:cNvPr>
          <p:cNvSpPr/>
          <p:nvPr/>
        </p:nvSpPr>
        <p:spPr>
          <a:xfrm>
            <a:off x="6580221" y="2234656"/>
            <a:ext cx="3527891" cy="62020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7420D90-67F1-49A2-B16B-F73D92DEB319}"/>
              </a:ext>
            </a:extLst>
          </p:cNvPr>
          <p:cNvSpPr txBox="1"/>
          <p:nvPr/>
        </p:nvSpPr>
        <p:spPr>
          <a:xfrm>
            <a:off x="10621049" y="2395384"/>
            <a:ext cx="6886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OPA1</a:t>
            </a:r>
            <a:endParaRPr lang="en-AT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D1C88F4-AA43-40D2-B0E9-54FACCF0A312}"/>
              </a:ext>
            </a:extLst>
          </p:cNvPr>
          <p:cNvSpPr txBox="1"/>
          <p:nvPr/>
        </p:nvSpPr>
        <p:spPr>
          <a:xfrm>
            <a:off x="10621049" y="3812704"/>
            <a:ext cx="8738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TOM40</a:t>
            </a:r>
            <a:endParaRPr lang="en-AT" dirty="0"/>
          </a:p>
        </p:txBody>
      </p:sp>
    </p:spTree>
    <p:extLst>
      <p:ext uri="{BB962C8B-B14F-4D97-AF65-F5344CB8AC3E}">
        <p14:creationId xmlns:p14="http://schemas.microsoft.com/office/powerpoint/2010/main" val="13859511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23C9E54D-5C5B-4926-A769-7A6216045318}"/>
              </a:ext>
            </a:extLst>
          </p:cNvPr>
          <p:cNvSpPr txBox="1"/>
          <p:nvPr/>
        </p:nvSpPr>
        <p:spPr>
          <a:xfrm>
            <a:off x="58322" y="3653190"/>
            <a:ext cx="15716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OMA1</a:t>
            </a:r>
            <a:endParaRPr kumimoji="0" lang="en-AT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893AABE6-4AA8-48EC-8A88-5C71293AB20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4136" y="855279"/>
            <a:ext cx="3899502" cy="3888000"/>
          </a:xfrm>
          <a:prstGeom prst="rect">
            <a:avLst/>
          </a:prstGeom>
        </p:spPr>
      </p:pic>
      <p:sp>
        <p:nvSpPr>
          <p:cNvPr id="14" name="Rectangle 13">
            <a:extLst>
              <a:ext uri="{FF2B5EF4-FFF2-40B4-BE49-F238E27FC236}">
                <a16:creationId xmlns:a16="http://schemas.microsoft.com/office/drawing/2014/main" id="{DDB42B73-954D-4A26-9923-5A3B6494A5BA}"/>
              </a:ext>
            </a:extLst>
          </p:cNvPr>
          <p:cNvSpPr/>
          <p:nvPr/>
        </p:nvSpPr>
        <p:spPr>
          <a:xfrm>
            <a:off x="844135" y="3580769"/>
            <a:ext cx="3473593" cy="421843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AT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7F3AFF2-7F27-4A69-907C-C8451ED2A56E}"/>
              </a:ext>
            </a:extLst>
          </p:cNvPr>
          <p:cNvSpPr txBox="1"/>
          <p:nvPr/>
        </p:nvSpPr>
        <p:spPr>
          <a:xfrm>
            <a:off x="895059" y="479039"/>
            <a:ext cx="33041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WT  #1  #2  WT  #1  #2  WT #2 #1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662BE42-949C-4B0A-A380-B13CDD03E803}"/>
              </a:ext>
            </a:extLst>
          </p:cNvPr>
          <p:cNvSpPr txBox="1"/>
          <p:nvPr/>
        </p:nvSpPr>
        <p:spPr>
          <a:xfrm>
            <a:off x="1507966" y="137769"/>
            <a:ext cx="6274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B" sz="160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7BCD4D1-6079-43DB-AC0F-958C331C3CE5}"/>
              </a:ext>
            </a:extLst>
          </p:cNvPr>
          <p:cNvSpPr txBox="1"/>
          <p:nvPr/>
        </p:nvSpPr>
        <p:spPr>
          <a:xfrm>
            <a:off x="3640043" y="137769"/>
            <a:ext cx="56350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B" sz="160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9B17832-D576-498F-AEFF-B1A5B505D3F0}"/>
              </a:ext>
            </a:extLst>
          </p:cNvPr>
          <p:cNvSpPr txBox="1"/>
          <p:nvPr/>
        </p:nvSpPr>
        <p:spPr>
          <a:xfrm>
            <a:off x="2581831" y="137769"/>
            <a:ext cx="56350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B" sz="160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</a:p>
        </p:txBody>
      </p:sp>
    </p:spTree>
    <p:extLst>
      <p:ext uri="{BB962C8B-B14F-4D97-AF65-F5344CB8AC3E}">
        <p14:creationId xmlns:p14="http://schemas.microsoft.com/office/powerpoint/2010/main" val="98467824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extBox 28">
            <a:extLst>
              <a:ext uri="{FF2B5EF4-FFF2-40B4-BE49-F238E27FC236}">
                <a16:creationId xmlns:a16="http://schemas.microsoft.com/office/drawing/2014/main" id="{9C6A06ED-3ECA-4D13-AF69-3E83D7221F24}"/>
              </a:ext>
            </a:extLst>
          </p:cNvPr>
          <p:cNvSpPr txBox="1"/>
          <p:nvPr/>
        </p:nvSpPr>
        <p:spPr>
          <a:xfrm>
            <a:off x="902368" y="2474321"/>
            <a:ext cx="9477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irt3</a:t>
            </a:r>
            <a:endParaRPr kumimoji="0" lang="en-AT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DF2704CF-548A-48CE-8415-BADF043CF2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9196B662-7824-423E-8712-AF57347CEC86}" type="slidenum">
              <a:rPr kumimoji="0" lang="en-AT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4</a:t>
            </a:fld>
            <a:endParaRPr kumimoji="0" lang="en-AT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0C71799E-5620-4E3C-B11D-8ECB9569E76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99641" y="1291380"/>
            <a:ext cx="3705444" cy="2592000"/>
          </a:xfrm>
          <a:prstGeom prst="rect">
            <a:avLst/>
          </a:prstGeom>
        </p:spPr>
      </p:pic>
      <p:sp>
        <p:nvSpPr>
          <p:cNvPr id="15" name="Rectangle 14">
            <a:extLst>
              <a:ext uri="{FF2B5EF4-FFF2-40B4-BE49-F238E27FC236}">
                <a16:creationId xmlns:a16="http://schemas.microsoft.com/office/drawing/2014/main" id="{C7DD7D73-69F4-4970-A9E1-023D17E77B38}"/>
              </a:ext>
            </a:extLst>
          </p:cNvPr>
          <p:cNvSpPr/>
          <p:nvPr/>
        </p:nvSpPr>
        <p:spPr>
          <a:xfrm>
            <a:off x="1910288" y="2510576"/>
            <a:ext cx="3419729" cy="393032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AT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807317BD-33E8-4485-A882-1B7B4B9BE9B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43" t="15" r="664" b="627"/>
          <a:stretch/>
        </p:blipFill>
        <p:spPr>
          <a:xfrm>
            <a:off x="6053590" y="1251801"/>
            <a:ext cx="4060113" cy="2592000"/>
          </a:xfrm>
          <a:prstGeom prst="rect">
            <a:avLst/>
          </a:prstGeom>
        </p:spPr>
      </p:pic>
      <p:sp>
        <p:nvSpPr>
          <p:cNvPr id="17" name="Rectangle 16">
            <a:extLst>
              <a:ext uri="{FF2B5EF4-FFF2-40B4-BE49-F238E27FC236}">
                <a16:creationId xmlns:a16="http://schemas.microsoft.com/office/drawing/2014/main" id="{4E5040C1-114A-4C67-8782-A1CAC54866E0}"/>
              </a:ext>
            </a:extLst>
          </p:cNvPr>
          <p:cNvSpPr/>
          <p:nvPr/>
        </p:nvSpPr>
        <p:spPr>
          <a:xfrm>
            <a:off x="6053590" y="1636104"/>
            <a:ext cx="3785653" cy="393032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AT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AB17470-7B4F-4517-B4FD-49E54BF970DC}"/>
              </a:ext>
            </a:extLst>
          </p:cNvPr>
          <p:cNvSpPr txBox="1"/>
          <p:nvPr/>
        </p:nvSpPr>
        <p:spPr>
          <a:xfrm>
            <a:off x="1897479" y="889785"/>
            <a:ext cx="33041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WT  #1  #2  WT  #1  #2  WT #2 #1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83C9132-937B-48E8-977B-1CF513C28304}"/>
              </a:ext>
            </a:extLst>
          </p:cNvPr>
          <p:cNvSpPr txBox="1"/>
          <p:nvPr/>
        </p:nvSpPr>
        <p:spPr>
          <a:xfrm>
            <a:off x="2544616" y="484949"/>
            <a:ext cx="6274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B" sz="160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0B745B7-CA99-4704-B543-BC9330870CCE}"/>
              </a:ext>
            </a:extLst>
          </p:cNvPr>
          <p:cNvSpPr txBox="1"/>
          <p:nvPr/>
        </p:nvSpPr>
        <p:spPr>
          <a:xfrm>
            <a:off x="4554444" y="484949"/>
            <a:ext cx="56350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B" sz="160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21CF1C5-6BE7-4EBB-9052-73E3241A4A0C}"/>
              </a:ext>
            </a:extLst>
          </p:cNvPr>
          <p:cNvSpPr txBox="1"/>
          <p:nvPr/>
        </p:nvSpPr>
        <p:spPr>
          <a:xfrm>
            <a:off x="3618481" y="484949"/>
            <a:ext cx="56350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B" sz="160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0FB68BC1-BAA8-4CF5-83B9-A8F629254CD1}"/>
              </a:ext>
            </a:extLst>
          </p:cNvPr>
          <p:cNvSpPr txBox="1"/>
          <p:nvPr/>
        </p:nvSpPr>
        <p:spPr>
          <a:xfrm>
            <a:off x="6118184" y="910168"/>
            <a:ext cx="365042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WT #1   #2   WT  #1   #2   WT #2   #1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DCDF6C64-CEA4-4A97-BD80-AC23AD4C4A47}"/>
              </a:ext>
            </a:extLst>
          </p:cNvPr>
          <p:cNvSpPr txBox="1"/>
          <p:nvPr/>
        </p:nvSpPr>
        <p:spPr>
          <a:xfrm>
            <a:off x="6676643" y="654226"/>
            <a:ext cx="6274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B" sz="160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08496910-397E-4021-A49E-8BAF392C5FE0}"/>
              </a:ext>
            </a:extLst>
          </p:cNvPr>
          <p:cNvSpPr txBox="1"/>
          <p:nvPr/>
        </p:nvSpPr>
        <p:spPr>
          <a:xfrm>
            <a:off x="9082741" y="654226"/>
            <a:ext cx="56350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B" sz="160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5F2C39FE-C270-4DBF-9FE8-3830B50FA48D}"/>
              </a:ext>
            </a:extLst>
          </p:cNvPr>
          <p:cNvSpPr txBox="1"/>
          <p:nvPr/>
        </p:nvSpPr>
        <p:spPr>
          <a:xfrm>
            <a:off x="7865624" y="654226"/>
            <a:ext cx="56350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B" sz="160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AE49EB4-12F2-47AE-A588-9E7D258E45EC}"/>
              </a:ext>
            </a:extLst>
          </p:cNvPr>
          <p:cNvSpPr txBox="1"/>
          <p:nvPr/>
        </p:nvSpPr>
        <p:spPr>
          <a:xfrm>
            <a:off x="10113703" y="1597907"/>
            <a:ext cx="6880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DRP1</a:t>
            </a:r>
            <a:endParaRPr lang="en-AT" dirty="0"/>
          </a:p>
        </p:txBody>
      </p:sp>
    </p:spTree>
    <p:extLst>
      <p:ext uri="{BB962C8B-B14F-4D97-AF65-F5344CB8AC3E}">
        <p14:creationId xmlns:p14="http://schemas.microsoft.com/office/powerpoint/2010/main" val="8175846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CD16B04-8214-460A-8133-E8810CBFDCE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80559" y="907430"/>
            <a:ext cx="3803777" cy="3492000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364C268D-0EBB-4797-961C-49B1D09B2FFF}"/>
              </a:ext>
            </a:extLst>
          </p:cNvPr>
          <p:cNvSpPr/>
          <p:nvPr/>
        </p:nvSpPr>
        <p:spPr>
          <a:xfrm>
            <a:off x="1180559" y="3415173"/>
            <a:ext cx="3803777" cy="421843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AT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160E037-3CFC-40CF-83D2-437F8DE2AE52}"/>
              </a:ext>
            </a:extLst>
          </p:cNvPr>
          <p:cNvSpPr txBox="1"/>
          <p:nvPr/>
        </p:nvSpPr>
        <p:spPr>
          <a:xfrm>
            <a:off x="5252884" y="3472923"/>
            <a:ext cx="15716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TOM40</a:t>
            </a:r>
            <a:endParaRPr kumimoji="0" lang="en-AT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11F255F-8387-4B17-BEBA-1EA96104B45C}"/>
              </a:ext>
            </a:extLst>
          </p:cNvPr>
          <p:cNvSpPr txBox="1"/>
          <p:nvPr/>
        </p:nvSpPr>
        <p:spPr>
          <a:xfrm>
            <a:off x="1243014" y="499419"/>
            <a:ext cx="365042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WT #1   #2   WT  #1   #2    WT #2   #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F6F798C-F6AF-4827-9E0F-9DECDC9D78BE}"/>
              </a:ext>
            </a:extLst>
          </p:cNvPr>
          <p:cNvSpPr txBox="1"/>
          <p:nvPr/>
        </p:nvSpPr>
        <p:spPr>
          <a:xfrm>
            <a:off x="1777684" y="192374"/>
            <a:ext cx="6274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B" sz="160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24B345E-4E90-474B-81FB-865F7460C0B5}"/>
              </a:ext>
            </a:extLst>
          </p:cNvPr>
          <p:cNvSpPr txBox="1"/>
          <p:nvPr/>
        </p:nvSpPr>
        <p:spPr>
          <a:xfrm>
            <a:off x="4139584" y="192374"/>
            <a:ext cx="56350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B" sz="160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6F8C7C0-B099-4364-BB84-7EEE4C0576DA}"/>
              </a:ext>
            </a:extLst>
          </p:cNvPr>
          <p:cNvSpPr txBox="1"/>
          <p:nvPr/>
        </p:nvSpPr>
        <p:spPr>
          <a:xfrm>
            <a:off x="3012912" y="192374"/>
            <a:ext cx="56350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B" sz="160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</a:p>
        </p:txBody>
      </p:sp>
    </p:spTree>
    <p:extLst>
      <p:ext uri="{BB962C8B-B14F-4D97-AF65-F5344CB8AC3E}">
        <p14:creationId xmlns:p14="http://schemas.microsoft.com/office/powerpoint/2010/main" val="1901467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23</TotalTime>
  <Words>136</Words>
  <Application>Microsoft Office PowerPoint</Application>
  <PresentationFormat>Widescreen</PresentationFormat>
  <Paragraphs>38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Offic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mi Elamin Mustafa Mohammed</dc:creator>
  <cp:lastModifiedBy>Sami Elamin Mustafa Mohammed</cp:lastModifiedBy>
  <cp:revision>3</cp:revision>
  <dcterms:created xsi:type="dcterms:W3CDTF">2021-11-06T20:08:19Z</dcterms:created>
  <dcterms:modified xsi:type="dcterms:W3CDTF">2021-11-07T23:15:37Z</dcterms:modified>
</cp:coreProperties>
</file>